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8" r:id="rId2"/>
    <p:sldId id="259" r:id="rId3"/>
    <p:sldId id="260" r:id="rId4"/>
    <p:sldId id="261" r:id="rId5"/>
    <p:sldId id="26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r Ealand" userId="7fc1e729-a38a-437c-baa1-37c07a26fa5f" providerId="ADAL" clId="{C706BCAF-B2E3-4C9B-8ED9-4DE0EB640862}"/>
    <pc:docChg chg="delSld modSld">
      <pc:chgData name="Christopher Ealand" userId="7fc1e729-a38a-437c-baa1-37c07a26fa5f" providerId="ADAL" clId="{C706BCAF-B2E3-4C9B-8ED9-4DE0EB640862}" dt="2023-07-28T14:12:34.816" v="6" actId="6549"/>
      <pc:docMkLst>
        <pc:docMk/>
      </pc:docMkLst>
      <pc:sldChg chg="modSp mod">
        <pc:chgData name="Christopher Ealand" userId="7fc1e729-a38a-437c-baa1-37c07a26fa5f" providerId="ADAL" clId="{C706BCAF-B2E3-4C9B-8ED9-4DE0EB640862}" dt="2023-07-28T14:12:34.816" v="6" actId="6549"/>
        <pc:sldMkLst>
          <pc:docMk/>
          <pc:sldMk cId="2976372299" sldId="257"/>
        </pc:sldMkLst>
        <pc:spChg chg="mod">
          <ac:chgData name="Christopher Ealand" userId="7fc1e729-a38a-437c-baa1-37c07a26fa5f" providerId="ADAL" clId="{C706BCAF-B2E3-4C9B-8ED9-4DE0EB640862}" dt="2023-07-28T14:12:34.816" v="6" actId="6549"/>
          <ac:spMkLst>
            <pc:docMk/>
            <pc:sldMk cId="2976372299" sldId="257"/>
            <ac:spMk id="24" creationId="{DD2D03D2-FB4E-C472-6E7A-3FD7F9585592}"/>
          </ac:spMkLst>
        </pc:spChg>
      </pc:sldChg>
      <pc:sldChg chg="del">
        <pc:chgData name="Christopher Ealand" userId="7fc1e729-a38a-437c-baa1-37c07a26fa5f" providerId="ADAL" clId="{C706BCAF-B2E3-4C9B-8ED9-4DE0EB640862}" dt="2023-07-28T14:12:04.564" v="0" actId="47"/>
        <pc:sldMkLst>
          <pc:docMk/>
          <pc:sldMk cId="1479375781" sldId="272"/>
        </pc:sldMkLst>
      </pc:sldChg>
      <pc:sldChg chg="del">
        <pc:chgData name="Christopher Ealand" userId="7fc1e729-a38a-437c-baa1-37c07a26fa5f" providerId="ADAL" clId="{C706BCAF-B2E3-4C9B-8ED9-4DE0EB640862}" dt="2023-07-28T14:12:05.691" v="1" actId="47"/>
        <pc:sldMkLst>
          <pc:docMk/>
          <pc:sldMk cId="4139930805" sldId="273"/>
        </pc:sldMkLst>
      </pc:sldChg>
    </pc:docChg>
  </pc:docChgLst>
  <pc:docChgLst>
    <pc:chgData name="Christopher Ealand" userId="7fc1e729-a38a-437c-baa1-37c07a26fa5f" providerId="ADAL" clId="{CBF590C7-A2AC-4285-810A-734443BC6790}"/>
    <pc:docChg chg="delSld">
      <pc:chgData name="Christopher Ealand" userId="7fc1e729-a38a-437c-baa1-37c07a26fa5f" providerId="ADAL" clId="{CBF590C7-A2AC-4285-810A-734443BC6790}" dt="2023-08-07T13:04:18.888" v="0" actId="47"/>
      <pc:docMkLst>
        <pc:docMk/>
      </pc:docMkLst>
      <pc:sldChg chg="del">
        <pc:chgData name="Christopher Ealand" userId="7fc1e729-a38a-437c-baa1-37c07a26fa5f" providerId="ADAL" clId="{CBF590C7-A2AC-4285-810A-734443BC6790}" dt="2023-08-07T13:04:18.888" v="0" actId="47"/>
        <pc:sldMkLst>
          <pc:docMk/>
          <pc:sldMk cId="2976372299" sldId="257"/>
        </pc:sldMkLst>
      </pc:sldChg>
    </pc:docChg>
  </pc:docChgLst>
  <pc:docChgLst>
    <pc:chgData name="Christopher Ealand" userId="7fc1e729-a38a-437c-baa1-37c07a26fa5f" providerId="ADAL" clId="{C0CE31E7-AF02-4F21-89F4-8174CA9B91DB}"/>
    <pc:docChg chg="modSld">
      <pc:chgData name="Christopher Ealand" userId="7fc1e729-a38a-437c-baa1-37c07a26fa5f" providerId="ADAL" clId="{C0CE31E7-AF02-4F21-89F4-8174CA9B91DB}" dt="2023-07-30T19:45:21.390" v="1" actId="12788"/>
      <pc:docMkLst>
        <pc:docMk/>
      </pc:docMkLst>
      <pc:sldChg chg="modSp mod">
        <pc:chgData name="Christopher Ealand" userId="7fc1e729-a38a-437c-baa1-37c07a26fa5f" providerId="ADAL" clId="{C0CE31E7-AF02-4F21-89F4-8174CA9B91DB}" dt="2023-07-30T19:45:21.390" v="1" actId="12788"/>
        <pc:sldMkLst>
          <pc:docMk/>
          <pc:sldMk cId="2976372299" sldId="257"/>
        </pc:sldMkLst>
        <pc:grpChg chg="mod">
          <ac:chgData name="Christopher Ealand" userId="7fc1e729-a38a-437c-baa1-37c07a26fa5f" providerId="ADAL" clId="{C0CE31E7-AF02-4F21-89F4-8174CA9B91DB}" dt="2023-07-30T19:45:21.390" v="1" actId="12788"/>
          <ac:grpSpMkLst>
            <pc:docMk/>
            <pc:sldMk cId="2976372299" sldId="257"/>
            <ac:grpSpMk id="2" creationId="{2E352947-5DBD-EEB2-F41A-D5854D8924AD}"/>
          </ac:grpSpMkLst>
        </pc:gr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03015657890726"/>
          <c:y val="5.4274076393397881E-2"/>
          <c:w val="0.84461736718756764"/>
          <c:h val="0.649987763403773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Overall positivity_coded results_15062023.xlsx]HIV comparison'!$L$2</c:f>
              <c:strCache>
                <c:ptCount val="1"/>
                <c:pt idx="0">
                  <c:v>HIV positive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Overall positivity_coded results_15062023.xlsx]HIV comparison'!$O$3:$O$14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8.286999999999999</c:v>
                  </c:pt>
                  <c:pt idx="2">
                    <c:v>8.8929999999999989</c:v>
                  </c:pt>
                  <c:pt idx="3">
                    <c:v>0</c:v>
                  </c:pt>
                  <c:pt idx="4">
                    <c:v>4.4850000000000003</c:v>
                  </c:pt>
                  <c:pt idx="5">
                    <c:v>7.2130000000000001</c:v>
                  </c:pt>
                  <c:pt idx="6">
                    <c:v>7.9889999999999999</c:v>
                  </c:pt>
                  <c:pt idx="7">
                    <c:v>6.1210000000000004</c:v>
                  </c:pt>
                  <c:pt idx="8">
                    <c:v>4.4850000000000003</c:v>
                  </c:pt>
                  <c:pt idx="9">
                    <c:v>8.286999999999999</c:v>
                  </c:pt>
                  <c:pt idx="10">
                    <c:v>9.0860000000000003</c:v>
                  </c:pt>
                  <c:pt idx="11">
                    <c:v>9.1240000000000006</c:v>
                  </c:pt>
                </c:numCache>
              </c:numRef>
            </c:plus>
            <c:minus>
              <c:numRef>
                <c:f>'[Overall positivity_coded results_15062023.xlsx]HIV comparison'!$O$3:$O$14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8.286999999999999</c:v>
                  </c:pt>
                  <c:pt idx="2">
                    <c:v>8.8929999999999989</c:v>
                  </c:pt>
                  <c:pt idx="3">
                    <c:v>0</c:v>
                  </c:pt>
                  <c:pt idx="4">
                    <c:v>4.4850000000000003</c:v>
                  </c:pt>
                  <c:pt idx="5">
                    <c:v>7.2130000000000001</c:v>
                  </c:pt>
                  <c:pt idx="6">
                    <c:v>7.9889999999999999</c:v>
                  </c:pt>
                  <c:pt idx="7">
                    <c:v>6.1210000000000004</c:v>
                  </c:pt>
                  <c:pt idx="8">
                    <c:v>4.4850000000000003</c:v>
                  </c:pt>
                  <c:pt idx="9">
                    <c:v>8.286999999999999</c:v>
                  </c:pt>
                  <c:pt idx="10">
                    <c:v>9.0860000000000003</c:v>
                  </c:pt>
                  <c:pt idx="11">
                    <c:v>9.12400000000000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Overall positivity_coded results_15062023.xlsx]HIV comparison'!$K$3:$K$14</c:f>
              <c:strCache>
                <c:ptCount val="12"/>
                <c:pt idx="0">
                  <c:v>MGIT (S)</c:v>
                </c:pt>
                <c:pt idx="1">
                  <c:v>MGIT (TS)</c:v>
                </c:pt>
                <c:pt idx="2">
                  <c:v>Auramine (S)</c:v>
                </c:pt>
                <c:pt idx="3">
                  <c:v>Auramine (TS)</c:v>
                </c:pt>
                <c:pt idx="4">
                  <c:v>GeneXpert (S)</c:v>
                </c:pt>
                <c:pt idx="5">
                  <c:v>GeneXpert (TS)</c:v>
                </c:pt>
                <c:pt idx="6">
                  <c:v>DMN-Tre (S)</c:v>
                </c:pt>
                <c:pt idx="7">
                  <c:v>DMN-Tre (TS)</c:v>
                </c:pt>
                <c:pt idx="8">
                  <c:v>CF-dependent (S)</c:v>
                </c:pt>
                <c:pt idx="9">
                  <c:v>CF-dependent (TS)</c:v>
                </c:pt>
                <c:pt idx="10">
                  <c:v>CF-independent (S)</c:v>
                </c:pt>
                <c:pt idx="11">
                  <c:v>CF-independent (TS)</c:v>
                </c:pt>
              </c:strCache>
            </c:strRef>
          </c:cat>
          <c:val>
            <c:numRef>
              <c:f>'[Overall positivity_coded results_15062023.xlsx]HIV comparison'!$L$3:$L$14</c:f>
              <c:numCache>
                <c:formatCode>General</c:formatCode>
                <c:ptCount val="12"/>
                <c:pt idx="0">
                  <c:v>100</c:v>
                </c:pt>
                <c:pt idx="1">
                  <c:v>29.03</c:v>
                </c:pt>
                <c:pt idx="2">
                  <c:v>61.29</c:v>
                </c:pt>
                <c:pt idx="3">
                  <c:v>0</c:v>
                </c:pt>
                <c:pt idx="4">
                  <c:v>93.55</c:v>
                </c:pt>
                <c:pt idx="5">
                  <c:v>19.350000000000001</c:v>
                </c:pt>
                <c:pt idx="6">
                  <c:v>25.81</c:v>
                </c:pt>
                <c:pt idx="7">
                  <c:v>12.9</c:v>
                </c:pt>
                <c:pt idx="8">
                  <c:v>93.55</c:v>
                </c:pt>
                <c:pt idx="9">
                  <c:v>70.97</c:v>
                </c:pt>
                <c:pt idx="10">
                  <c:v>54.84</c:v>
                </c:pt>
                <c:pt idx="11">
                  <c:v>48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5C-4CFB-8765-AE906EA79A70}"/>
            </c:ext>
          </c:extLst>
        </c:ser>
        <c:ser>
          <c:idx val="1"/>
          <c:order val="1"/>
          <c:tx>
            <c:strRef>
              <c:f>'[Overall positivity_coded results_15062023.xlsx]HIV comparison'!$M$2</c:f>
              <c:strCache>
                <c:ptCount val="1"/>
                <c:pt idx="0">
                  <c:v>HIV negative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Overall positivity_coded results_15062023.xlsx]HIV comparison'!$P$3:$P$14</c:f>
                <c:numCache>
                  <c:formatCode>General</c:formatCode>
                  <c:ptCount val="12"/>
                  <c:pt idx="0">
                    <c:v>4.0529999999999999</c:v>
                  </c:pt>
                  <c:pt idx="1">
                    <c:v>6.9329999999999998</c:v>
                  </c:pt>
                  <c:pt idx="2">
                    <c:v>5.4260000000000002</c:v>
                  </c:pt>
                  <c:pt idx="3">
                    <c:v>1.8870000000000002</c:v>
                  </c:pt>
                  <c:pt idx="4">
                    <c:v>4.6950000000000003</c:v>
                  </c:pt>
                  <c:pt idx="5">
                    <c:v>5.2069999999999999</c:v>
                  </c:pt>
                  <c:pt idx="6">
                    <c:v>6.3659999999999997</c:v>
                  </c:pt>
                  <c:pt idx="7">
                    <c:v>5.2069999999999999</c:v>
                  </c:pt>
                  <c:pt idx="8">
                    <c:v>3.6630000000000003</c:v>
                  </c:pt>
                  <c:pt idx="9">
                    <c:v>6.2469999999999999</c:v>
                  </c:pt>
                  <c:pt idx="10">
                    <c:v>6.5670000000000002</c:v>
                  </c:pt>
                  <c:pt idx="11">
                    <c:v>5.2069999999999999</c:v>
                  </c:pt>
                </c:numCache>
              </c:numRef>
            </c:plus>
            <c:minus>
              <c:numRef>
                <c:f>'[Overall positivity_coded results_15062023.xlsx]HIV comparison'!$P$3:$P$14</c:f>
                <c:numCache>
                  <c:formatCode>General</c:formatCode>
                  <c:ptCount val="12"/>
                  <c:pt idx="0">
                    <c:v>4.0529999999999999</c:v>
                  </c:pt>
                  <c:pt idx="1">
                    <c:v>6.9329999999999998</c:v>
                  </c:pt>
                  <c:pt idx="2">
                    <c:v>5.4260000000000002</c:v>
                  </c:pt>
                  <c:pt idx="3">
                    <c:v>1.8870000000000002</c:v>
                  </c:pt>
                  <c:pt idx="4">
                    <c:v>4.6950000000000003</c:v>
                  </c:pt>
                  <c:pt idx="5">
                    <c:v>5.2069999999999999</c:v>
                  </c:pt>
                  <c:pt idx="6">
                    <c:v>6.3659999999999997</c:v>
                  </c:pt>
                  <c:pt idx="7">
                    <c:v>5.2069999999999999</c:v>
                  </c:pt>
                  <c:pt idx="8">
                    <c:v>3.6630000000000003</c:v>
                  </c:pt>
                  <c:pt idx="9">
                    <c:v>6.2469999999999999</c:v>
                  </c:pt>
                  <c:pt idx="10">
                    <c:v>6.5670000000000002</c:v>
                  </c:pt>
                  <c:pt idx="11">
                    <c:v>5.206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Overall positivity_coded results_15062023.xlsx]HIV comparison'!$K$3:$K$14</c:f>
              <c:strCache>
                <c:ptCount val="12"/>
                <c:pt idx="0">
                  <c:v>MGIT (S)</c:v>
                </c:pt>
                <c:pt idx="1">
                  <c:v>MGIT (TS)</c:v>
                </c:pt>
                <c:pt idx="2">
                  <c:v>Auramine (S)</c:v>
                </c:pt>
                <c:pt idx="3">
                  <c:v>Auramine (TS)</c:v>
                </c:pt>
                <c:pt idx="4">
                  <c:v>GeneXpert (S)</c:v>
                </c:pt>
                <c:pt idx="5">
                  <c:v>GeneXpert (TS)</c:v>
                </c:pt>
                <c:pt idx="6">
                  <c:v>DMN-Tre (S)</c:v>
                </c:pt>
                <c:pt idx="7">
                  <c:v>DMN-Tre (TS)</c:v>
                </c:pt>
                <c:pt idx="8">
                  <c:v>CF-dependent (S)</c:v>
                </c:pt>
                <c:pt idx="9">
                  <c:v>CF-dependent (TS)</c:v>
                </c:pt>
                <c:pt idx="10">
                  <c:v>CF-independent (S)</c:v>
                </c:pt>
                <c:pt idx="11">
                  <c:v>CF-independent (TS)</c:v>
                </c:pt>
              </c:strCache>
            </c:strRef>
          </c:cat>
          <c:val>
            <c:numRef>
              <c:f>'[Overall positivity_coded results_15062023.xlsx]HIV comparison'!$M$3:$M$14</c:f>
              <c:numCache>
                <c:formatCode>General</c:formatCode>
                <c:ptCount val="12"/>
                <c:pt idx="0">
                  <c:v>90.57</c:v>
                </c:pt>
                <c:pt idx="1">
                  <c:v>49.059999999999995</c:v>
                </c:pt>
                <c:pt idx="2">
                  <c:v>81.13</c:v>
                </c:pt>
                <c:pt idx="3">
                  <c:v>1.8870000000000002</c:v>
                </c:pt>
                <c:pt idx="4">
                  <c:v>86.79</c:v>
                </c:pt>
                <c:pt idx="5">
                  <c:v>16.98</c:v>
                </c:pt>
                <c:pt idx="6">
                  <c:v>30.19</c:v>
                </c:pt>
                <c:pt idx="7">
                  <c:v>16.98</c:v>
                </c:pt>
                <c:pt idx="8">
                  <c:v>92.45</c:v>
                </c:pt>
                <c:pt idx="9">
                  <c:v>71.7</c:v>
                </c:pt>
                <c:pt idx="10">
                  <c:v>33.96</c:v>
                </c:pt>
                <c:pt idx="11">
                  <c:v>16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5C-4CFB-8765-AE906EA79A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28944"/>
        <c:axId val="150331344"/>
      </c:barChart>
      <c:catAx>
        <c:axId val="1503289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0331344"/>
        <c:crosses val="autoZero"/>
        <c:auto val="1"/>
        <c:lblAlgn val="ctr"/>
        <c:lblOffset val="100"/>
        <c:noMultiLvlLbl val="0"/>
      </c:catAx>
      <c:valAx>
        <c:axId val="150331344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1200" b="1" dirty="0">
                    <a:solidFill>
                      <a:schemeClr val="tx1"/>
                    </a:solidFill>
                  </a:rPr>
                  <a:t>Proportion of positivity (%)</a:t>
                </a:r>
              </a:p>
            </c:rich>
          </c:tx>
          <c:layout>
            <c:manualLayout>
              <c:xMode val="edge"/>
              <c:yMode val="edge"/>
              <c:x val="3.4840858530813231E-3"/>
              <c:y val="8.701544568318926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32894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7416018317744073"/>
          <c:y val="3.7425152104412114E-2"/>
          <c:w val="0.20350367833990785"/>
          <c:h val="0.179997313049533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299BB1-4302-42A1-8A03-66B214719319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E5CDDB-9B9F-4CB6-BEC3-FEE2667C58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332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51C6CE-BB2A-4FDF-B12D-F4AA1CB073C0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6295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3473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899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820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557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7760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743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62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359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324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169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077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22B15-633A-4204-88B1-44310EF83A01}" type="datetimeFigureOut">
              <a:rPr lang="en-GB" smtClean="0"/>
              <a:t>07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6C38E-314B-4969-A327-3B7C448AF6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7749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microsoft.com/office/2007/relationships/hdphoto" Target="../media/hdphoto9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microsoft.com/office/2007/relationships/hdphoto" Target="../media/hdphoto12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5.wdp"/><Relationship Id="rId13" Type="http://schemas.openxmlformats.org/officeDocument/2006/relationships/image" Target="../media/image21.png"/><Relationship Id="rId18" Type="http://schemas.openxmlformats.org/officeDocument/2006/relationships/image" Target="../media/image24.png"/><Relationship Id="rId26" Type="http://schemas.openxmlformats.org/officeDocument/2006/relationships/image" Target="../media/image29.png"/><Relationship Id="rId3" Type="http://schemas.microsoft.com/office/2007/relationships/hdphoto" Target="../media/hdphoto13.wdp"/><Relationship Id="rId21" Type="http://schemas.openxmlformats.org/officeDocument/2006/relationships/image" Target="../media/image26.png"/><Relationship Id="rId7" Type="http://schemas.openxmlformats.org/officeDocument/2006/relationships/image" Target="../media/image18.png"/><Relationship Id="rId12" Type="http://schemas.microsoft.com/office/2007/relationships/hdphoto" Target="../media/hdphoto17.wdp"/><Relationship Id="rId17" Type="http://schemas.openxmlformats.org/officeDocument/2006/relationships/image" Target="../media/image23.png"/><Relationship Id="rId25" Type="http://schemas.microsoft.com/office/2007/relationships/hdphoto" Target="../media/hdphoto22.wdp"/><Relationship Id="rId2" Type="http://schemas.openxmlformats.org/officeDocument/2006/relationships/image" Target="../media/image15.png"/><Relationship Id="rId16" Type="http://schemas.microsoft.com/office/2007/relationships/hdphoto" Target="../media/hdphoto19.wdp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0.png"/><Relationship Id="rId24" Type="http://schemas.openxmlformats.org/officeDocument/2006/relationships/image" Target="../media/image28.png"/><Relationship Id="rId5" Type="http://schemas.microsoft.com/office/2007/relationships/hdphoto" Target="../media/hdphoto14.wdp"/><Relationship Id="rId15" Type="http://schemas.openxmlformats.org/officeDocument/2006/relationships/image" Target="../media/image22.png"/><Relationship Id="rId23" Type="http://schemas.microsoft.com/office/2007/relationships/hdphoto" Target="../media/hdphoto21.wdp"/><Relationship Id="rId10" Type="http://schemas.microsoft.com/office/2007/relationships/hdphoto" Target="../media/hdphoto16.wdp"/><Relationship Id="rId19" Type="http://schemas.microsoft.com/office/2007/relationships/hdphoto" Target="../media/hdphoto20.wdp"/><Relationship Id="rId4" Type="http://schemas.openxmlformats.org/officeDocument/2006/relationships/image" Target="../media/image16.png"/><Relationship Id="rId9" Type="http://schemas.openxmlformats.org/officeDocument/2006/relationships/image" Target="../media/image19.png"/><Relationship Id="rId14" Type="http://schemas.microsoft.com/office/2007/relationships/hdphoto" Target="../media/hdphoto18.wdp"/><Relationship Id="rId22" Type="http://schemas.openxmlformats.org/officeDocument/2006/relationships/image" Target="../media/image27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25.wdp"/><Relationship Id="rId13" Type="http://schemas.openxmlformats.org/officeDocument/2006/relationships/image" Target="../media/image37.png"/><Relationship Id="rId18" Type="http://schemas.microsoft.com/office/2007/relationships/hdphoto" Target="../media/hdphoto28.wdp"/><Relationship Id="rId3" Type="http://schemas.openxmlformats.org/officeDocument/2006/relationships/image" Target="../media/image31.png"/><Relationship Id="rId21" Type="http://schemas.openxmlformats.org/officeDocument/2006/relationships/image" Target="../media/image42.png"/><Relationship Id="rId7" Type="http://schemas.openxmlformats.org/officeDocument/2006/relationships/image" Target="../media/image33.png"/><Relationship Id="rId12" Type="http://schemas.openxmlformats.org/officeDocument/2006/relationships/image" Target="../media/image36.png"/><Relationship Id="rId17" Type="http://schemas.openxmlformats.org/officeDocument/2006/relationships/image" Target="../media/image40.png"/><Relationship Id="rId2" Type="http://schemas.openxmlformats.org/officeDocument/2006/relationships/image" Target="../media/image30.png"/><Relationship Id="rId16" Type="http://schemas.microsoft.com/office/2007/relationships/hdphoto" Target="../media/hdphoto27.wdp"/><Relationship Id="rId20" Type="http://schemas.microsoft.com/office/2007/relationships/hdphoto" Target="../media/hdphoto29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4.wdp"/><Relationship Id="rId11" Type="http://schemas.microsoft.com/office/2007/relationships/hdphoto" Target="../media/hdphoto26.wdp"/><Relationship Id="rId5" Type="http://schemas.openxmlformats.org/officeDocument/2006/relationships/image" Target="../media/image32.png"/><Relationship Id="rId15" Type="http://schemas.openxmlformats.org/officeDocument/2006/relationships/image" Target="../media/image39.png"/><Relationship Id="rId10" Type="http://schemas.openxmlformats.org/officeDocument/2006/relationships/image" Target="../media/image35.png"/><Relationship Id="rId19" Type="http://schemas.openxmlformats.org/officeDocument/2006/relationships/image" Target="../media/image41.png"/><Relationship Id="rId4" Type="http://schemas.microsoft.com/office/2007/relationships/hdphoto" Target="../media/hdphoto23.wdp"/><Relationship Id="rId9" Type="http://schemas.openxmlformats.org/officeDocument/2006/relationships/image" Target="../media/image34.png"/><Relationship Id="rId14" Type="http://schemas.openxmlformats.org/officeDocument/2006/relationships/image" Target="../media/image38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2.wdp"/><Relationship Id="rId13" Type="http://schemas.openxmlformats.org/officeDocument/2006/relationships/image" Target="../media/image49.png"/><Relationship Id="rId3" Type="http://schemas.microsoft.com/office/2007/relationships/hdphoto" Target="../media/hdphoto30.wdp"/><Relationship Id="rId7" Type="http://schemas.openxmlformats.org/officeDocument/2006/relationships/image" Target="../media/image46.png"/><Relationship Id="rId12" Type="http://schemas.microsoft.com/office/2007/relationships/hdphoto" Target="../media/hdphoto34.wdp"/><Relationship Id="rId17" Type="http://schemas.openxmlformats.org/officeDocument/2006/relationships/image" Target="../media/image52.png"/><Relationship Id="rId2" Type="http://schemas.openxmlformats.org/officeDocument/2006/relationships/image" Target="../media/image43.png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1.wdp"/><Relationship Id="rId11" Type="http://schemas.openxmlformats.org/officeDocument/2006/relationships/image" Target="../media/image48.png"/><Relationship Id="rId5" Type="http://schemas.openxmlformats.org/officeDocument/2006/relationships/image" Target="../media/image45.png"/><Relationship Id="rId15" Type="http://schemas.openxmlformats.org/officeDocument/2006/relationships/image" Target="../media/image50.png"/><Relationship Id="rId10" Type="http://schemas.microsoft.com/office/2007/relationships/hdphoto" Target="../media/hdphoto33.wdp"/><Relationship Id="rId4" Type="http://schemas.openxmlformats.org/officeDocument/2006/relationships/image" Target="../media/image44.png"/><Relationship Id="rId9" Type="http://schemas.openxmlformats.org/officeDocument/2006/relationships/image" Target="../media/image47.png"/><Relationship Id="rId14" Type="http://schemas.microsoft.com/office/2007/relationships/hdphoto" Target="../media/hdphoto35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BE67584-C76D-9E41-8B29-C949ADCE5EAA}"/>
              </a:ext>
            </a:extLst>
          </p:cNvPr>
          <p:cNvGrpSpPr/>
          <p:nvPr/>
        </p:nvGrpSpPr>
        <p:grpSpPr>
          <a:xfrm>
            <a:off x="181077" y="63500"/>
            <a:ext cx="6495845" cy="7851838"/>
            <a:chOff x="181077" y="63500"/>
            <a:chExt cx="6495845" cy="7851838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3D6CDCC-A1E2-AC6A-F75C-9C92108FF58C}"/>
                </a:ext>
              </a:extLst>
            </p:cNvPr>
            <p:cNvSpPr txBox="1"/>
            <p:nvPr/>
          </p:nvSpPr>
          <p:spPr>
            <a:xfrm>
              <a:off x="2331000" y="63500"/>
              <a:ext cx="2196000" cy="5232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rticipant 3077</a:t>
              </a:r>
            </a:p>
            <a:p>
              <a:pPr algn="ctr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(high bacterial load)</a:t>
              </a:r>
              <a:endParaRPr lang="en-GB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356330AA-761B-451D-7666-A15E49E1E9D1}"/>
                </a:ext>
              </a:extLst>
            </p:cNvPr>
            <p:cNvGrpSpPr/>
            <p:nvPr/>
          </p:nvGrpSpPr>
          <p:grpSpPr>
            <a:xfrm>
              <a:off x="498746" y="699700"/>
              <a:ext cx="5860509" cy="5775312"/>
              <a:chOff x="498746" y="699700"/>
              <a:chExt cx="5860509" cy="5775312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6A8590CF-F9E8-85FC-485A-9EA3D4A82F81}"/>
                  </a:ext>
                </a:extLst>
              </p:cNvPr>
              <p:cNvGrpSpPr/>
              <p:nvPr/>
            </p:nvGrpSpPr>
            <p:grpSpPr>
              <a:xfrm>
                <a:off x="498746" y="699700"/>
                <a:ext cx="5860509" cy="5775312"/>
                <a:chOff x="137696" y="26600"/>
                <a:chExt cx="5860509" cy="5775312"/>
              </a:xfrm>
            </p:grpSpPr>
            <p:pic>
              <p:nvPicPr>
                <p:cNvPr id="57" name="Picture 56">
                  <a:extLst>
                    <a:ext uri="{FF2B5EF4-FFF2-40B4-BE49-F238E27FC236}">
                      <a16:creationId xmlns:a16="http://schemas.microsoft.com/office/drawing/2014/main" id="{3B748E5F-A93B-829E-F735-D2B3FB9659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rcRect l="21994" t="14831" r="2976" b="14831"/>
                <a:stretch/>
              </p:blipFill>
              <p:spPr>
                <a:xfrm>
                  <a:off x="3812986" y="3101910"/>
                  <a:ext cx="1048830" cy="1314141"/>
                </a:xfrm>
                <a:prstGeom prst="rect">
                  <a:avLst/>
                </a:prstGeom>
              </p:spPr>
            </p:pic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40BC75E3-F458-CB95-1094-931FCCDBD9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17980" t="27770" r="25446" b="10825"/>
                <a:stretch/>
              </p:blipFill>
              <p:spPr>
                <a:xfrm>
                  <a:off x="509213" y="3101910"/>
                  <a:ext cx="1010695" cy="1319886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8E413467-3BA6-9D8E-417C-597488557E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</a:extLst>
                </a:blip>
                <a:srcRect l="40099" t="16666" r="11249" b="34228"/>
                <a:stretch/>
              </p:blipFill>
              <p:spPr>
                <a:xfrm>
                  <a:off x="521559" y="329544"/>
                  <a:ext cx="998350" cy="1319886"/>
                </a:xfrm>
                <a:prstGeom prst="rect">
                  <a:avLst/>
                </a:prstGeom>
              </p:spPr>
            </p:pic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09E4A4BD-CB99-B44F-DBC1-5DFF808142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32629" t="40346" r="4002" b="-147"/>
                <a:stretch/>
              </p:blipFill>
              <p:spPr>
                <a:xfrm>
                  <a:off x="1586263" y="328999"/>
                  <a:ext cx="1049394" cy="1320432"/>
                </a:xfrm>
                <a:prstGeom prst="rect">
                  <a:avLst/>
                </a:prstGeom>
              </p:spPr>
            </p:pic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B162A5FC-922D-7540-9BF7-0EBDB728E2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1405" y="177800"/>
                  <a:ext cx="3240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9132A0D-5480-D32D-A93E-EBFAF123D5B4}"/>
                    </a:ext>
                  </a:extLst>
                </p:cNvPr>
                <p:cNvSpPr txBox="1"/>
                <p:nvPr/>
              </p:nvSpPr>
              <p:spPr>
                <a:xfrm rot="16200000">
                  <a:off x="-1073804" y="1541915"/>
                  <a:ext cx="2700000" cy="276999"/>
                </a:xfrm>
                <a:prstGeom prst="rect">
                  <a:avLst/>
                </a:prstGeom>
                <a:solidFill>
                  <a:schemeClr val="tx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uramine</a:t>
                  </a:r>
                  <a:endParaRPr lang="en-GB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29E1AC44-1728-E30C-417D-1B5CF8004C99}"/>
                    </a:ext>
                  </a:extLst>
                </p:cNvPr>
                <p:cNvSpPr txBox="1"/>
                <p:nvPr/>
              </p:nvSpPr>
              <p:spPr>
                <a:xfrm>
                  <a:off x="1606707" y="26600"/>
                  <a:ext cx="104939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utum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48D9378D-FF3F-2F89-30B0-26FF2DBB57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2205" y="177799"/>
                  <a:ext cx="2196000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10BE3C52-E6B7-CF47-4790-EC76E860CABD}"/>
                    </a:ext>
                  </a:extLst>
                </p:cNvPr>
                <p:cNvSpPr txBox="1"/>
                <p:nvPr/>
              </p:nvSpPr>
              <p:spPr>
                <a:xfrm>
                  <a:off x="4422805" y="26600"/>
                  <a:ext cx="108000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ngue swab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389CF625-AD6D-9676-6A82-33CA4EA231D6}"/>
                    </a:ext>
                  </a:extLst>
                </p:cNvPr>
                <p:cNvSpPr txBox="1"/>
                <p:nvPr/>
              </p:nvSpPr>
              <p:spPr>
                <a:xfrm rot="16200000">
                  <a:off x="-1073804" y="4313412"/>
                  <a:ext cx="2700000" cy="27699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N-Tre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A569C20B-63F4-7ED1-E3D6-41C6C88AD252}"/>
                    </a:ext>
                  </a:extLst>
                </p:cNvPr>
                <p:cNvSpPr txBox="1"/>
                <p:nvPr/>
              </p:nvSpPr>
              <p:spPr>
                <a:xfrm>
                  <a:off x="458110" y="316297"/>
                  <a:ext cx="720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182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BD5C6F3-0ABC-997A-2750-ADA6EA571077}"/>
                    </a:ext>
                  </a:extLst>
                </p:cNvPr>
                <p:cNvSpPr txBox="1"/>
                <p:nvPr/>
              </p:nvSpPr>
              <p:spPr>
                <a:xfrm>
                  <a:off x="527007" y="3101910"/>
                  <a:ext cx="720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21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1EC840E7-A87B-3B1D-26C3-B37EFCBE5933}"/>
                    </a:ext>
                  </a:extLst>
                </p:cNvPr>
                <p:cNvSpPr txBox="1"/>
                <p:nvPr/>
              </p:nvSpPr>
              <p:spPr>
                <a:xfrm>
                  <a:off x="3548310" y="3115319"/>
                  <a:ext cx="10493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2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9D1D2B47-AF3E-72E0-21EE-1C16C0D787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24008" t="13026" r="15340" b="22522"/>
                <a:stretch/>
              </p:blipFill>
              <p:spPr>
                <a:xfrm>
                  <a:off x="2691476" y="328998"/>
                  <a:ext cx="1056176" cy="1319886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07DCEB5D-31AF-3F2B-8221-B49BB5FB17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13973" t="13152" r="17077" b="12569"/>
                <a:stretch/>
              </p:blipFill>
              <p:spPr>
                <a:xfrm>
                  <a:off x="527007" y="1719565"/>
                  <a:ext cx="992902" cy="1300734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DE7A0770-0707-BC3B-DF30-0903100E93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19548" t="18854" r="30194" b="31092"/>
                <a:stretch/>
              </p:blipFill>
              <p:spPr>
                <a:xfrm>
                  <a:off x="1586263" y="1719566"/>
                  <a:ext cx="1049394" cy="1300734"/>
                </a:xfrm>
                <a:prstGeom prst="rect">
                  <a:avLst/>
                </a:prstGeom>
              </p:spPr>
            </p:pic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B7ADAF6A-CC2B-0578-6E74-8D0ACD1860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32957" t="14727" r="15087" b="14727"/>
                <a:stretch/>
              </p:blipFill>
              <p:spPr>
                <a:xfrm>
                  <a:off x="2700214" y="1719565"/>
                  <a:ext cx="1047438" cy="1300734"/>
                </a:xfrm>
                <a:prstGeom prst="rect">
                  <a:avLst/>
                </a:prstGeom>
              </p:spPr>
            </p:pic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D817AC1C-2366-823A-9B71-A8F83C6229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30775" t="19969" r="5856" b="2147"/>
                <a:stretch/>
              </p:blipFill>
              <p:spPr>
                <a:xfrm>
                  <a:off x="1581580" y="3115320"/>
                  <a:ext cx="1049394" cy="1300734"/>
                </a:xfrm>
                <a:prstGeom prst="rect">
                  <a:avLst/>
                </a:prstGeom>
              </p:spPr>
            </p:pic>
            <p:pic>
              <p:nvPicPr>
                <p:cNvPr id="38" name="Picture 37">
                  <a:extLst>
                    <a:ext uri="{FF2B5EF4-FFF2-40B4-BE49-F238E27FC236}">
                      <a16:creationId xmlns:a16="http://schemas.microsoft.com/office/drawing/2014/main" id="{392A1232-7E74-3F75-23B2-49F929924D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18738" t="-6" r="16637" b="29427"/>
                <a:stretch/>
              </p:blipFill>
              <p:spPr>
                <a:xfrm>
                  <a:off x="509213" y="4496191"/>
                  <a:ext cx="1010695" cy="1300732"/>
                </a:xfrm>
                <a:prstGeom prst="rect">
                  <a:avLst/>
                </a:prstGeom>
              </p:spPr>
            </p:pic>
            <p:pic>
              <p:nvPicPr>
                <p:cNvPr id="45" name="Picture 44">
                  <a:extLst>
                    <a:ext uri="{FF2B5EF4-FFF2-40B4-BE49-F238E27FC236}">
                      <a16:creationId xmlns:a16="http://schemas.microsoft.com/office/drawing/2014/main" id="{B4450719-6BBE-0962-0EC4-099A33EB03B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0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17265" t="-485" r="18918" b="32857"/>
                <a:stretch/>
              </p:blipFill>
              <p:spPr>
                <a:xfrm>
                  <a:off x="1593118" y="4496190"/>
                  <a:ext cx="1049394" cy="1300731"/>
                </a:xfrm>
                <a:prstGeom prst="rect">
                  <a:avLst/>
                </a:prstGeom>
              </p:spPr>
            </p:pic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83B1FF91-B882-C740-A250-2C5060A7A2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2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40446" t="33584" r="7251" b="8511"/>
                <a:stretch/>
              </p:blipFill>
              <p:spPr>
                <a:xfrm>
                  <a:off x="2715722" y="4508890"/>
                  <a:ext cx="1031930" cy="1288031"/>
                </a:xfrm>
                <a:prstGeom prst="rect">
                  <a:avLst/>
                </a:prstGeom>
              </p:spPr>
            </p:pic>
            <p:pic>
              <p:nvPicPr>
                <p:cNvPr id="55" name="Picture 54">
                  <a:extLst>
                    <a:ext uri="{FF2B5EF4-FFF2-40B4-BE49-F238E27FC236}">
                      <a16:creationId xmlns:a16="http://schemas.microsoft.com/office/drawing/2014/main" id="{07EF472E-CF7E-90EA-FF38-ECB2AFEB65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4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37645" t="24206" r="15035" b="24429"/>
                <a:stretch/>
              </p:blipFill>
              <p:spPr>
                <a:xfrm>
                  <a:off x="2689220" y="3101910"/>
                  <a:ext cx="1056176" cy="1314144"/>
                </a:xfrm>
                <a:prstGeom prst="rect">
                  <a:avLst/>
                </a:prstGeom>
              </p:spPr>
            </p:pic>
            <p:pic>
              <p:nvPicPr>
                <p:cNvPr id="59" name="Picture 58">
                  <a:extLst>
                    <a:ext uri="{FF2B5EF4-FFF2-40B4-BE49-F238E27FC236}">
                      <a16:creationId xmlns:a16="http://schemas.microsoft.com/office/drawing/2014/main" id="{ACD5187A-EF88-CA4F-1EFA-5103C80F71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6">
                  <a:extLst>
                    <a:ext uri="{BEBA8EAE-BF5A-486C-A8C5-ECC9F3942E4B}">
                      <a14:imgProps xmlns:a14="http://schemas.microsoft.com/office/drawing/2010/main">
                        <a14:imgLayer r:embed="rId27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</a:extLst>
                </a:blip>
                <a:srcRect l="36717" t="29916" r="12952" b="17291"/>
                <a:stretch/>
              </p:blipFill>
              <p:spPr>
                <a:xfrm>
                  <a:off x="4925605" y="3101910"/>
                  <a:ext cx="1029108" cy="1314138"/>
                </a:xfrm>
                <a:prstGeom prst="rect">
                  <a:avLst/>
                </a:prstGeom>
              </p:spPr>
            </p:pic>
          </p:grp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B9C6DC1E-2B4A-E29B-52AF-DD895C142458}"/>
                  </a:ext>
                </a:extLst>
              </p:cNvPr>
              <p:cNvSpPr/>
              <p:nvPr/>
            </p:nvSpPr>
            <p:spPr>
              <a:xfrm>
                <a:off x="4189712" y="1002098"/>
                <a:ext cx="2113351" cy="2700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4AD1E6F-F884-EE6F-E320-AE48683F47B7}"/>
                </a:ext>
              </a:extLst>
            </p:cNvPr>
            <p:cNvSpPr txBox="1"/>
            <p:nvPr/>
          </p:nvSpPr>
          <p:spPr>
            <a:xfrm>
              <a:off x="181077" y="6715009"/>
              <a:ext cx="6495845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A. Comparison of Auramine and DMN-Tre staining on sputum and tongue swabs sample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uramine and DMN-Tre staining in sputum and tongue swab-derived samples from </a:t>
              </a:r>
              <a:r>
                <a:rPr lang="en-US" sz="1200" b="1" u="sng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ticipant 3077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 Bright-green rods are considered positively stained. Magnification (100x) and scale bar represents 5 µm. Total number of bacilli scored for each sample type shown in top-left image. In some cases, no positively-stained bacteria were detected. A minimum of 100 fields of view were assessed following fluorescent staining.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B1B58F7-FB54-FB7D-6CA1-7CF4853E7938}"/>
                </a:ext>
              </a:extLst>
            </p:cNvPr>
            <p:cNvSpPr txBox="1"/>
            <p:nvPr/>
          </p:nvSpPr>
          <p:spPr>
            <a:xfrm>
              <a:off x="4591924" y="2199217"/>
              <a:ext cx="13386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No staining detected</a:t>
              </a:r>
              <a:endParaRPr lang="en-GB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34841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304D324-7407-296A-47E7-70718A26ECB4}"/>
              </a:ext>
            </a:extLst>
          </p:cNvPr>
          <p:cNvGrpSpPr/>
          <p:nvPr/>
        </p:nvGrpSpPr>
        <p:grpSpPr>
          <a:xfrm>
            <a:off x="181077" y="76200"/>
            <a:ext cx="6495845" cy="7839138"/>
            <a:chOff x="181077" y="76200"/>
            <a:chExt cx="6495845" cy="7839138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3D6CDCC-A1E2-AC6A-F75C-9C92108FF58C}"/>
                </a:ext>
              </a:extLst>
            </p:cNvPr>
            <p:cNvSpPr txBox="1"/>
            <p:nvPr/>
          </p:nvSpPr>
          <p:spPr>
            <a:xfrm>
              <a:off x="2348802" y="76200"/>
              <a:ext cx="2160397" cy="5232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rticipant 3094</a:t>
              </a:r>
            </a:p>
            <a:p>
              <a:pPr algn="ctr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(very high bacterial load)</a:t>
              </a:r>
              <a:endParaRPr lang="en-GB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2F4BCF37-32A2-CB71-98C0-40F9D0B66151}"/>
                </a:ext>
              </a:extLst>
            </p:cNvPr>
            <p:cNvGrpSpPr/>
            <p:nvPr/>
          </p:nvGrpSpPr>
          <p:grpSpPr>
            <a:xfrm>
              <a:off x="498746" y="712400"/>
              <a:ext cx="5860509" cy="5775312"/>
              <a:chOff x="137696" y="26600"/>
              <a:chExt cx="5860509" cy="5775312"/>
            </a:xfrm>
          </p:grpSpPr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899E1C0C-E858-ABB1-35F5-6BC059D653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21705" t="28186" r="6997" b="7870"/>
              <a:stretch/>
            </p:blipFill>
            <p:spPr>
              <a:xfrm>
                <a:off x="510923" y="3097483"/>
                <a:ext cx="1026695" cy="1286448"/>
              </a:xfrm>
              <a:prstGeom prst="rect">
                <a:avLst/>
              </a:prstGeom>
            </p:spPr>
          </p:pic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57155054-1CE3-044A-F32D-45D2E6F0E2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1595" t="33976" r="11407" b="15859"/>
              <a:stretch/>
            </p:blipFill>
            <p:spPr>
              <a:xfrm>
                <a:off x="3826847" y="3097483"/>
                <a:ext cx="1038230" cy="1286449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873589CA-728E-D550-1582-1FCAB0E385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40751" t="34415" r="5559" b="15846"/>
              <a:stretch/>
            </p:blipFill>
            <p:spPr>
              <a:xfrm>
                <a:off x="3810886" y="316297"/>
                <a:ext cx="1038230" cy="1345829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87A6B27C-9FD7-034F-635D-F1CACEB0DE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30867" t="38552" r="7946" b="1074"/>
              <a:stretch/>
            </p:blipFill>
            <p:spPr>
              <a:xfrm>
                <a:off x="494287" y="329001"/>
                <a:ext cx="1049394" cy="1333133"/>
              </a:xfrm>
              <a:prstGeom prst="rect">
                <a:avLst/>
              </a:prstGeom>
            </p:spPr>
          </p:pic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B162A5FC-922D-7540-9BF7-0EBDB728E2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405" y="177800"/>
                <a:ext cx="324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9132A0D-5480-D32D-A93E-EBFAF123D5B4}"/>
                  </a:ext>
                </a:extLst>
              </p:cNvPr>
              <p:cNvSpPr txBox="1"/>
              <p:nvPr/>
            </p:nvSpPr>
            <p:spPr>
              <a:xfrm rot="16200000">
                <a:off x="-1073804" y="1541915"/>
                <a:ext cx="2700000" cy="276999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uramine</a:t>
                </a:r>
                <a:endParaRPr lang="en-GB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9E1AC44-1728-E30C-417D-1B5CF8004C99}"/>
                  </a:ext>
                </a:extLst>
              </p:cNvPr>
              <p:cNvSpPr txBox="1"/>
              <p:nvPr/>
            </p:nvSpPr>
            <p:spPr>
              <a:xfrm>
                <a:off x="1606707" y="26600"/>
                <a:ext cx="104939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putum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48D9378D-FF3F-2F89-30B0-26FF2DBB57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02205" y="177799"/>
                <a:ext cx="2196000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0BE3C52-E6B7-CF47-4790-EC76E860CABD}"/>
                  </a:ext>
                </a:extLst>
              </p:cNvPr>
              <p:cNvSpPr txBox="1"/>
              <p:nvPr/>
            </p:nvSpPr>
            <p:spPr>
              <a:xfrm>
                <a:off x="4422805" y="26600"/>
                <a:ext cx="108000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ongue swab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89CF625-AD6D-9676-6A82-33CA4EA231D6}"/>
                  </a:ext>
                </a:extLst>
              </p:cNvPr>
              <p:cNvSpPr txBox="1"/>
              <p:nvPr/>
            </p:nvSpPr>
            <p:spPr>
              <a:xfrm rot="16200000">
                <a:off x="-1073804" y="4313412"/>
                <a:ext cx="2700000" cy="276999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MN-Tre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569C20B-63F4-7ED1-E3D6-41C6C88AD252}"/>
                  </a:ext>
                </a:extLst>
              </p:cNvPr>
              <p:cNvSpPr txBox="1"/>
              <p:nvPr/>
            </p:nvSpPr>
            <p:spPr>
              <a:xfrm>
                <a:off x="458110" y="316297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362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BD5C6F3-0ABC-997A-2750-ADA6EA571077}"/>
                  </a:ext>
                </a:extLst>
              </p:cNvPr>
              <p:cNvSpPr txBox="1"/>
              <p:nvPr/>
            </p:nvSpPr>
            <p:spPr>
              <a:xfrm>
                <a:off x="527007" y="3101910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13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28B7C839-571B-F9F4-043C-37F3F7B65B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20752" t="17779" r="10976" b="3845"/>
              <a:stretch/>
            </p:blipFill>
            <p:spPr>
              <a:xfrm>
                <a:off x="1623272" y="329000"/>
                <a:ext cx="1007702" cy="1333127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316C59D3-28FA-6884-FAB3-F92C38413F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31683" t="31742" r="2399" b="4221"/>
              <a:stretch/>
            </p:blipFill>
            <p:spPr>
              <a:xfrm>
                <a:off x="2677533" y="328998"/>
                <a:ext cx="1067863" cy="1333128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BF312BE9-7A21-9334-A3EE-A00CE5E7AA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29848" t="27420" r="14576" b="18089"/>
              <a:stretch/>
            </p:blipFill>
            <p:spPr>
              <a:xfrm>
                <a:off x="494287" y="1735211"/>
                <a:ext cx="1049394" cy="1295204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55AFC8F-57BF-FB9F-8AF2-24035AFB32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33155" t="20783" r="9451" b="21277"/>
              <a:stretch/>
            </p:blipFill>
            <p:spPr>
              <a:xfrm>
                <a:off x="1612258" y="1731265"/>
                <a:ext cx="1007702" cy="1290509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3544B1B0-7E89-954A-6B87-C2864199C92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30384" t="31275" r="11449" b="13865"/>
              <a:stretch/>
            </p:blipFill>
            <p:spPr>
              <a:xfrm>
                <a:off x="2685864" y="1731265"/>
                <a:ext cx="1056176" cy="1290508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8E76FE75-9BF0-568F-3A14-4C22F1AE37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41134" t="35232" r="1582" b="311"/>
              <a:stretch/>
            </p:blipFill>
            <p:spPr>
              <a:xfrm>
                <a:off x="4914606" y="303600"/>
                <a:ext cx="1038231" cy="1345830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2948D4B-2FBC-CECB-0792-A089C1BD666C}"/>
                  </a:ext>
                </a:extLst>
              </p:cNvPr>
              <p:cNvSpPr txBox="1"/>
              <p:nvPr/>
            </p:nvSpPr>
            <p:spPr>
              <a:xfrm>
                <a:off x="3858706" y="325052"/>
                <a:ext cx="54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2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A8D95BB-5B57-154B-747A-7714E06EC302}"/>
                  </a:ext>
                </a:extLst>
              </p:cNvPr>
              <p:cNvSpPr txBox="1"/>
              <p:nvPr/>
            </p:nvSpPr>
            <p:spPr>
              <a:xfrm>
                <a:off x="3810886" y="3112918"/>
                <a:ext cx="7103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1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571224A5-BB4A-1524-F530-78299EE322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3988" t="4695" r="10383" b="13912"/>
              <a:stretch/>
            </p:blipFill>
            <p:spPr>
              <a:xfrm>
                <a:off x="1607238" y="3097851"/>
                <a:ext cx="1007702" cy="1290508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900C3A9B-52BE-9560-1B3E-DE68174B4E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7761" t="6431" r="16777" b="29761"/>
              <a:stretch/>
            </p:blipFill>
            <p:spPr>
              <a:xfrm>
                <a:off x="2677533" y="3097852"/>
                <a:ext cx="1073872" cy="1290508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C6E6A539-75BB-F15F-5CF7-0862172E7C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</a:extLst>
              </a:blip>
              <a:srcRect l="7795" t="823" r="20070" b="28639"/>
              <a:stretch/>
            </p:blipFill>
            <p:spPr>
              <a:xfrm>
                <a:off x="516985" y="4451910"/>
                <a:ext cx="1026695" cy="1350001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F1A864E4-80A5-9F54-6A2C-6692510776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23799" t="21575" r="4427" b="7978"/>
              <a:stretch/>
            </p:blipFill>
            <p:spPr>
              <a:xfrm>
                <a:off x="1606707" y="4447562"/>
                <a:ext cx="1007702" cy="1350001"/>
              </a:xfrm>
              <a:prstGeom prst="rect">
                <a:avLst/>
              </a:prstGeom>
            </p:spPr>
          </p:pic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3D25BD19-5EAC-577B-D309-29C91F0889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/>
              <a:srcRect l="26890" t="32379" r="8263" b="13896"/>
              <a:stretch/>
            </p:blipFill>
            <p:spPr>
              <a:xfrm>
                <a:off x="2677436" y="4444800"/>
                <a:ext cx="1073872" cy="1350002"/>
              </a:xfrm>
              <a:prstGeom prst="rect">
                <a:avLst/>
              </a:prstGeom>
            </p:spPr>
          </p:pic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640CFB7-776D-A363-AE08-95C538282523}"/>
                </a:ext>
              </a:extLst>
            </p:cNvPr>
            <p:cNvSpPr txBox="1"/>
            <p:nvPr/>
          </p:nvSpPr>
          <p:spPr>
            <a:xfrm>
              <a:off x="181077" y="6715009"/>
              <a:ext cx="6495845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B. Comparison of Auramine and DMN-Tre staining on sputum and tongue swabs sample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uramine and DMN-Tre staining in sputum and tongue swab-derived samples from </a:t>
              </a:r>
              <a:r>
                <a:rPr lang="en-US" sz="1200" b="1" u="sng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ticipant 3094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 Bright-green rods are considered positively stained. Magnification (100x) and scale bar represents 5 µm. Total number of bacilli scored for each sample type shown in top-left image. In some cases, no positively-stained bacteria were detected. A minimum of 100 fields of view were assessed following fluorescent staining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85061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4508CB0E-D632-1479-A122-30DFEF5B3F40}"/>
              </a:ext>
            </a:extLst>
          </p:cNvPr>
          <p:cNvGrpSpPr/>
          <p:nvPr/>
        </p:nvGrpSpPr>
        <p:grpSpPr>
          <a:xfrm>
            <a:off x="181077" y="76200"/>
            <a:ext cx="6495845" cy="7839138"/>
            <a:chOff x="181077" y="76200"/>
            <a:chExt cx="6495845" cy="7839138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3D6CDCC-A1E2-AC6A-F75C-9C92108FF58C}"/>
                </a:ext>
              </a:extLst>
            </p:cNvPr>
            <p:cNvSpPr txBox="1"/>
            <p:nvPr/>
          </p:nvSpPr>
          <p:spPr>
            <a:xfrm>
              <a:off x="2332806" y="76200"/>
              <a:ext cx="2192388" cy="5232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rticipant 3114</a:t>
              </a:r>
            </a:p>
            <a:p>
              <a:pPr algn="ctr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(very high bacterial load)</a:t>
              </a:r>
              <a:endParaRPr lang="en-GB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DEF8D493-3D37-5D66-47D2-E1EDE5C58A4F}"/>
                </a:ext>
              </a:extLst>
            </p:cNvPr>
            <p:cNvGrpSpPr/>
            <p:nvPr/>
          </p:nvGrpSpPr>
          <p:grpSpPr>
            <a:xfrm>
              <a:off x="498746" y="712400"/>
              <a:ext cx="5860509" cy="5775312"/>
              <a:chOff x="498746" y="712400"/>
              <a:chExt cx="5860509" cy="5775312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368B7230-D60B-636C-02C1-B555EAFC1534}"/>
                  </a:ext>
                </a:extLst>
              </p:cNvPr>
              <p:cNvGrpSpPr/>
              <p:nvPr/>
            </p:nvGrpSpPr>
            <p:grpSpPr>
              <a:xfrm>
                <a:off x="498746" y="712400"/>
                <a:ext cx="5860509" cy="5775312"/>
                <a:chOff x="137696" y="26600"/>
                <a:chExt cx="5860509" cy="5775312"/>
              </a:xfrm>
            </p:grpSpPr>
            <p:pic>
              <p:nvPicPr>
                <p:cNvPr id="56" name="Picture 55">
                  <a:extLst>
                    <a:ext uri="{FF2B5EF4-FFF2-40B4-BE49-F238E27FC236}">
                      <a16:creationId xmlns:a16="http://schemas.microsoft.com/office/drawing/2014/main" id="{7CB099DE-BB7A-1160-AB13-7F8358C9EE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35864" t="29053" r="7588" b="9661"/>
                <a:stretch/>
              </p:blipFill>
              <p:spPr>
                <a:xfrm>
                  <a:off x="3823586" y="3101910"/>
                  <a:ext cx="1038230" cy="1285971"/>
                </a:xfrm>
                <a:prstGeom prst="rect">
                  <a:avLst/>
                </a:prstGeom>
              </p:spPr>
            </p:pic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980F2DF9-192A-B333-9B2E-F46BE988D5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34892" t="30035" r="10933" b="16889"/>
                <a:stretch/>
              </p:blipFill>
              <p:spPr>
                <a:xfrm>
                  <a:off x="495174" y="3102386"/>
                  <a:ext cx="1042446" cy="1285973"/>
                </a:xfrm>
                <a:prstGeom prst="rect">
                  <a:avLst/>
                </a:prstGeom>
              </p:spPr>
            </p:pic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B771145D-961D-9833-4373-134066C3A6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21845" t="19028" r="18158" b="15583"/>
                <a:stretch/>
              </p:blipFill>
              <p:spPr>
                <a:xfrm>
                  <a:off x="495173" y="325053"/>
                  <a:ext cx="1042446" cy="1333128"/>
                </a:xfrm>
                <a:prstGeom prst="rect">
                  <a:avLst/>
                </a:prstGeom>
              </p:spPr>
            </p:pic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B162A5FC-922D-7540-9BF7-0EBDB728E2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1405" y="177800"/>
                  <a:ext cx="3240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9132A0D-5480-D32D-A93E-EBFAF123D5B4}"/>
                    </a:ext>
                  </a:extLst>
                </p:cNvPr>
                <p:cNvSpPr txBox="1"/>
                <p:nvPr/>
              </p:nvSpPr>
              <p:spPr>
                <a:xfrm rot="16200000">
                  <a:off x="-1073804" y="1541915"/>
                  <a:ext cx="2700000" cy="276999"/>
                </a:xfrm>
                <a:prstGeom prst="rect">
                  <a:avLst/>
                </a:prstGeom>
                <a:solidFill>
                  <a:schemeClr val="tx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uramine</a:t>
                  </a:r>
                  <a:endParaRPr lang="en-GB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29E1AC44-1728-E30C-417D-1B5CF8004C99}"/>
                    </a:ext>
                  </a:extLst>
                </p:cNvPr>
                <p:cNvSpPr txBox="1"/>
                <p:nvPr/>
              </p:nvSpPr>
              <p:spPr>
                <a:xfrm>
                  <a:off x="1606707" y="26600"/>
                  <a:ext cx="104939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utum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48D9378D-FF3F-2F89-30B0-26FF2DBB57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2205" y="177799"/>
                  <a:ext cx="2196000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10BE3C52-E6B7-CF47-4790-EC76E860CABD}"/>
                    </a:ext>
                  </a:extLst>
                </p:cNvPr>
                <p:cNvSpPr txBox="1"/>
                <p:nvPr/>
              </p:nvSpPr>
              <p:spPr>
                <a:xfrm>
                  <a:off x="4422805" y="26600"/>
                  <a:ext cx="108000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ngue swab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389CF625-AD6D-9676-6A82-33CA4EA231D6}"/>
                    </a:ext>
                  </a:extLst>
                </p:cNvPr>
                <p:cNvSpPr txBox="1"/>
                <p:nvPr/>
              </p:nvSpPr>
              <p:spPr>
                <a:xfrm rot="16200000">
                  <a:off x="-1073804" y="4313412"/>
                  <a:ext cx="2700000" cy="27699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N-Tre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A569C20B-63F4-7ED1-E3D6-41C6C88AD252}"/>
                    </a:ext>
                  </a:extLst>
                </p:cNvPr>
                <p:cNvSpPr txBox="1"/>
                <p:nvPr/>
              </p:nvSpPr>
              <p:spPr>
                <a:xfrm>
                  <a:off x="458110" y="316297"/>
                  <a:ext cx="720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383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BD5C6F3-0ABC-997A-2750-ADA6EA571077}"/>
                    </a:ext>
                  </a:extLst>
                </p:cNvPr>
                <p:cNvSpPr txBox="1"/>
                <p:nvPr/>
              </p:nvSpPr>
              <p:spPr>
                <a:xfrm>
                  <a:off x="527007" y="3101910"/>
                  <a:ext cx="720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17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9A8D95BB-5B57-154B-747A-7714E06EC302}"/>
                    </a:ext>
                  </a:extLst>
                </p:cNvPr>
                <p:cNvSpPr txBox="1"/>
                <p:nvPr/>
              </p:nvSpPr>
              <p:spPr>
                <a:xfrm>
                  <a:off x="3823586" y="3112918"/>
                  <a:ext cx="71031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1</a:t>
                  </a:r>
                  <a:endParaRPr lang="en-GB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182C00F7-0B39-7B85-1885-9D744E04870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</a:extLst>
                </a:blip>
                <a:srcRect l="37144" t="31378" r="7505" b="11371"/>
                <a:stretch/>
              </p:blipFill>
              <p:spPr>
                <a:xfrm>
                  <a:off x="1618096" y="333084"/>
                  <a:ext cx="996313" cy="1333129"/>
                </a:xfrm>
                <a:prstGeom prst="rect">
                  <a:avLst/>
                </a:prstGeom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9360D128-D973-0F41-BD15-0AFFBE9C690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26728" t="30911" r="15109" b="5521"/>
                <a:stretch/>
              </p:blipFill>
              <p:spPr>
                <a:xfrm>
                  <a:off x="2674881" y="327307"/>
                  <a:ext cx="1073873" cy="1333128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0171BB56-0AFF-9C08-AACB-F9E3D354E7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rcRect l="32089" t="13445" r="3215" b="32699"/>
                <a:stretch/>
              </p:blipFill>
              <p:spPr>
                <a:xfrm>
                  <a:off x="498223" y="1725417"/>
                  <a:ext cx="1026695" cy="1304088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050AA8F7-CBB5-A75E-33CA-A049B39B29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25784" t="20441" r="15430" b="8978"/>
                <a:stretch/>
              </p:blipFill>
              <p:spPr>
                <a:xfrm>
                  <a:off x="1615107" y="1722653"/>
                  <a:ext cx="996314" cy="1307762"/>
                </a:xfrm>
                <a:prstGeom prst="rect">
                  <a:avLst/>
                </a:prstGeom>
              </p:spPr>
            </p:pic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EAE13E2F-7036-A5B1-EFC9-184401BE48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l="21534" t="16445" r="27262" b="22199"/>
                <a:stretch/>
              </p:blipFill>
              <p:spPr>
                <a:xfrm>
                  <a:off x="2681502" y="1725416"/>
                  <a:ext cx="1067252" cy="1304089"/>
                </a:xfrm>
                <a:prstGeom prst="rect">
                  <a:avLst/>
                </a:prstGeom>
              </p:spPr>
            </p:pic>
            <p:pic>
              <p:nvPicPr>
                <p:cNvPr id="37" name="Picture 36">
                  <a:extLst>
                    <a:ext uri="{FF2B5EF4-FFF2-40B4-BE49-F238E27FC236}">
                      <a16:creationId xmlns:a16="http://schemas.microsoft.com/office/drawing/2014/main" id="{ECD1F382-58F9-ACEE-AFCE-97646DC3BD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/>
                <a:srcRect l="32360" t="37170" r="3447" b="3776"/>
                <a:stretch/>
              </p:blipFill>
              <p:spPr>
                <a:xfrm>
                  <a:off x="2685918" y="3112918"/>
                  <a:ext cx="1062836" cy="1274967"/>
                </a:xfrm>
                <a:prstGeom prst="rect">
                  <a:avLst/>
                </a:prstGeom>
              </p:spPr>
            </p:pic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7A957408-1C6C-A936-12A0-38B98D3B56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</a:extLst>
                </a:blip>
                <a:srcRect l="33179" t="35585" r="13462" b="16140"/>
                <a:stretch/>
              </p:blipFill>
              <p:spPr>
                <a:xfrm>
                  <a:off x="1623102" y="3112919"/>
                  <a:ext cx="996314" cy="1274966"/>
                </a:xfrm>
                <a:prstGeom prst="rect">
                  <a:avLst/>
                </a:prstGeom>
              </p:spPr>
            </p:pic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1C09B78E-FE4E-6DAA-AF6A-336134F5B4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</a:extLst>
                </a:blip>
                <a:srcRect l="28848" t="12739" r="10421" b="8792"/>
                <a:stretch/>
              </p:blipFill>
              <p:spPr>
                <a:xfrm>
                  <a:off x="495173" y="4443775"/>
                  <a:ext cx="1042446" cy="1358137"/>
                </a:xfrm>
                <a:prstGeom prst="rect">
                  <a:avLst/>
                </a:prstGeom>
              </p:spPr>
            </p:pic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D5A3D8D9-C62A-6F4C-E026-0BDBEB0DD5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</a:extLst>
                </a:blip>
                <a:srcRect l="34927" t="11742" r="7416" b="2391"/>
                <a:stretch/>
              </p:blipFill>
              <p:spPr>
                <a:xfrm>
                  <a:off x="1615107" y="4443775"/>
                  <a:ext cx="996314" cy="1358137"/>
                </a:xfrm>
                <a:prstGeom prst="rect">
                  <a:avLst/>
                </a:prstGeom>
              </p:spPr>
            </p:pic>
            <p:pic>
              <p:nvPicPr>
                <p:cNvPr id="52" name="Picture 51">
                  <a:extLst>
                    <a:ext uri="{FF2B5EF4-FFF2-40B4-BE49-F238E27FC236}">
                      <a16:creationId xmlns:a16="http://schemas.microsoft.com/office/drawing/2014/main" id="{D44EF883-1F0E-B84B-E0F8-8DA8CF0D42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1"/>
                <a:srcRect l="-679" t="1721" r="31699" b="28778"/>
                <a:stretch/>
              </p:blipFill>
              <p:spPr>
                <a:xfrm>
                  <a:off x="2656102" y="4451910"/>
                  <a:ext cx="1092652" cy="1349999"/>
                </a:xfrm>
                <a:prstGeom prst="rect">
                  <a:avLst/>
                </a:prstGeom>
              </p:spPr>
            </p:pic>
          </p:grpSp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E62A9522-04A9-DD36-18B1-F80EC1C9ED93}"/>
                  </a:ext>
                </a:extLst>
              </p:cNvPr>
              <p:cNvSpPr/>
              <p:nvPr/>
            </p:nvSpPr>
            <p:spPr>
              <a:xfrm>
                <a:off x="4177012" y="1002098"/>
                <a:ext cx="2113351" cy="2700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D58EB81-DCCF-BA16-5B15-5EFC2AE4FBE9}"/>
                </a:ext>
              </a:extLst>
            </p:cNvPr>
            <p:cNvSpPr txBox="1"/>
            <p:nvPr/>
          </p:nvSpPr>
          <p:spPr>
            <a:xfrm>
              <a:off x="181077" y="6715009"/>
              <a:ext cx="6495845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C. Comparison of Auramine and DMN-Tre staining on sputum and tongue swabs sample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uramine and DMN-Tre staining in sputum and tongue swab-derived samples from </a:t>
              </a:r>
              <a:r>
                <a:rPr lang="en-US" sz="1200" b="1" u="sng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ticipant 3114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 Bright-green rods are considered positively stained. Magnification (100x) and scale bar represents 5 µm. Total number of bacilli scored for each sample type shown in top-left image. In some cases, no positively-stained bacteria were detected. A minimum of 100 fields of view were assessed following fluorescent staining.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886CCE7-0814-C7B0-BD0E-E826E3BCC2B9}"/>
                </a:ext>
              </a:extLst>
            </p:cNvPr>
            <p:cNvSpPr txBox="1"/>
            <p:nvPr/>
          </p:nvSpPr>
          <p:spPr>
            <a:xfrm>
              <a:off x="4591924" y="2199217"/>
              <a:ext cx="13386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No staining detected</a:t>
              </a:r>
              <a:endParaRPr lang="en-GB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918338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CA683950-D339-CF30-6F68-68CEC8BEBA09}"/>
              </a:ext>
            </a:extLst>
          </p:cNvPr>
          <p:cNvGrpSpPr/>
          <p:nvPr/>
        </p:nvGrpSpPr>
        <p:grpSpPr>
          <a:xfrm>
            <a:off x="181077" y="76200"/>
            <a:ext cx="6495845" cy="7839138"/>
            <a:chOff x="181077" y="76200"/>
            <a:chExt cx="6495845" cy="7839138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4D795B2-5B96-F069-B2AB-792BE7060DC8}"/>
                </a:ext>
              </a:extLst>
            </p:cNvPr>
            <p:cNvSpPr txBox="1"/>
            <p:nvPr/>
          </p:nvSpPr>
          <p:spPr>
            <a:xfrm>
              <a:off x="181077" y="6715009"/>
              <a:ext cx="6495845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D. Comparison of Auramine and DMN-Tre staining on sputum and tongue swabs sample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uramine and DMN-Tre staining in sputum and tongue swab-derived samples from </a:t>
              </a:r>
              <a:r>
                <a:rPr lang="en-US" sz="1200" b="1" u="sng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ticipant 3157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 Bright-green rods are considered positively stained. Magnification (100x) and scale bar represents 5 µm. Total number of bacilli scored for each sample type shown in top-left image. In some cases, no positively-stained bacteria were detected. A minimum of 100 fields of view were assessed following fluorescent staining.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2192342-7409-8CE6-A5DD-14CF9B1A0F6F}"/>
                </a:ext>
              </a:extLst>
            </p:cNvPr>
            <p:cNvGrpSpPr/>
            <p:nvPr/>
          </p:nvGrpSpPr>
          <p:grpSpPr>
            <a:xfrm>
              <a:off x="498746" y="76200"/>
              <a:ext cx="5860509" cy="6411512"/>
              <a:chOff x="498746" y="76200"/>
              <a:chExt cx="5860509" cy="6411512"/>
            </a:xfrm>
          </p:grpSpPr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F2D68490-CB00-2E1B-B529-2CD0E0FFAC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15936" r="23481" b="28302"/>
              <a:stretch/>
            </p:blipFill>
            <p:spPr>
              <a:xfrm>
                <a:off x="862451" y="3798188"/>
                <a:ext cx="1020875" cy="1336701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4DA49E27-DA7C-0F78-4B49-9BB601C3F8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8971" t="28313" r="16157" b="3550"/>
              <a:stretch/>
            </p:blipFill>
            <p:spPr>
              <a:xfrm>
                <a:off x="856223" y="1010852"/>
                <a:ext cx="1020874" cy="1336715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EE2D8783-24D7-0972-9CA0-86452AE8FF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14679" t="14862" r="28282" b="20318"/>
              <a:stretch/>
            </p:blipFill>
            <p:spPr>
              <a:xfrm>
                <a:off x="1934147" y="1016695"/>
                <a:ext cx="1026695" cy="1336707"/>
              </a:xfrm>
              <a:prstGeom prst="rect">
                <a:avLst/>
              </a:prstGeom>
            </p:spPr>
          </p:pic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B162A5FC-922D-7540-9BF7-0EBDB728E2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2455" y="863600"/>
                <a:ext cx="324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9132A0D-5480-D32D-A93E-EBFAF123D5B4}"/>
                  </a:ext>
                </a:extLst>
              </p:cNvPr>
              <p:cNvSpPr txBox="1"/>
              <p:nvPr/>
            </p:nvSpPr>
            <p:spPr>
              <a:xfrm rot="16200000">
                <a:off x="-712754" y="2227715"/>
                <a:ext cx="2700000" cy="276999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uramine</a:t>
                </a:r>
                <a:endParaRPr lang="en-GB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9E1AC44-1728-E30C-417D-1B5CF8004C99}"/>
                  </a:ext>
                </a:extLst>
              </p:cNvPr>
              <p:cNvSpPr txBox="1"/>
              <p:nvPr/>
            </p:nvSpPr>
            <p:spPr>
              <a:xfrm>
                <a:off x="1967757" y="712400"/>
                <a:ext cx="104939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putum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48D9378D-FF3F-2F89-30B0-26FF2DBB57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63255" y="863599"/>
                <a:ext cx="2196000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0BE3C52-E6B7-CF47-4790-EC76E860CABD}"/>
                  </a:ext>
                </a:extLst>
              </p:cNvPr>
              <p:cNvSpPr txBox="1"/>
              <p:nvPr/>
            </p:nvSpPr>
            <p:spPr>
              <a:xfrm>
                <a:off x="4783855" y="712400"/>
                <a:ext cx="108000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ongue swab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89CF625-AD6D-9676-6A82-33CA4EA231D6}"/>
                  </a:ext>
                </a:extLst>
              </p:cNvPr>
              <p:cNvSpPr txBox="1"/>
              <p:nvPr/>
            </p:nvSpPr>
            <p:spPr>
              <a:xfrm rot="16200000">
                <a:off x="-712754" y="4999212"/>
                <a:ext cx="2700000" cy="276999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MN-Tre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569C20B-63F4-7ED1-E3D6-41C6C88AD252}"/>
                  </a:ext>
                </a:extLst>
              </p:cNvPr>
              <p:cNvSpPr txBox="1"/>
              <p:nvPr/>
            </p:nvSpPr>
            <p:spPr>
              <a:xfrm>
                <a:off x="1153664" y="1002333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145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BD5C6F3-0ABC-997A-2750-ADA6EA571077}"/>
                  </a:ext>
                </a:extLst>
              </p:cNvPr>
              <p:cNvSpPr txBox="1"/>
              <p:nvPr/>
            </p:nvSpPr>
            <p:spPr>
              <a:xfrm>
                <a:off x="888057" y="3787710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1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A8D95BB-5B57-154B-747A-7714E06EC302}"/>
                  </a:ext>
                </a:extLst>
              </p:cNvPr>
              <p:cNvSpPr txBox="1"/>
              <p:nvPr/>
            </p:nvSpPr>
            <p:spPr>
              <a:xfrm>
                <a:off x="4171936" y="3798718"/>
                <a:ext cx="7103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0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75F29000-5FFF-6AAB-12EF-E582C1CC8C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20413" t="26701" r="20921" b="15488"/>
              <a:stretch/>
            </p:blipFill>
            <p:spPr>
              <a:xfrm>
                <a:off x="3030387" y="1018188"/>
                <a:ext cx="1092652" cy="1329379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0E2422B8-C1AB-0C22-EA92-0D0BFC83BD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15274" t="6196" r="25523" b="19840"/>
              <a:stretch/>
            </p:blipFill>
            <p:spPr>
              <a:xfrm>
                <a:off x="856223" y="2429542"/>
                <a:ext cx="1017441" cy="1286672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85ABD836-F407-B821-6338-9486382E21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23132" t="21714" r="25514" b="17573"/>
              <a:stretch/>
            </p:blipFill>
            <p:spPr>
              <a:xfrm>
                <a:off x="1934147" y="2429542"/>
                <a:ext cx="1026695" cy="1286672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D109E53E-F287-3C5E-C4A1-869DFCA514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-20000"/>
                        </a14:imgEffect>
                      </a14:imgLayer>
                    </a14:imgProps>
                  </a:ext>
                </a:extLst>
              </a:blip>
              <a:srcRect l="8813" t="22757" r="48142" b="25073"/>
              <a:stretch/>
            </p:blipFill>
            <p:spPr>
              <a:xfrm>
                <a:off x="3024295" y="2429542"/>
                <a:ext cx="1085510" cy="1274967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8A046F08-37A8-3235-B2BD-CFC16E7A5B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3295" t="1175" r="17817" b="22381"/>
              <a:stretch/>
            </p:blipFill>
            <p:spPr>
              <a:xfrm>
                <a:off x="4192584" y="1009963"/>
                <a:ext cx="1017582" cy="1337604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2948D4B-2FBC-CECB-0792-A089C1BD666C}"/>
                  </a:ext>
                </a:extLst>
              </p:cNvPr>
              <p:cNvSpPr txBox="1"/>
              <p:nvPr/>
            </p:nvSpPr>
            <p:spPr>
              <a:xfrm>
                <a:off x="4151051" y="1016695"/>
                <a:ext cx="54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= 3</a:t>
                </a:r>
                <a:endParaRPr lang="en-GB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FC08D760-76B5-7F17-E385-B972BD9382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33124" t="21525" r="14231" b="16962"/>
              <a:stretch/>
            </p:blipFill>
            <p:spPr>
              <a:xfrm>
                <a:off x="5286140" y="1016696"/>
                <a:ext cx="1017582" cy="1329378"/>
              </a:xfrm>
              <a:prstGeom prst="rect">
                <a:avLst/>
              </a:prstGeom>
            </p:spPr>
          </p:pic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CC46A29F-7245-AEA7-9070-F6ECE07FDF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22374" t="7211" r="18738" b="23529"/>
              <a:stretch/>
            </p:blipFill>
            <p:spPr>
              <a:xfrm>
                <a:off x="4192584" y="2429542"/>
                <a:ext cx="1017582" cy="1274967"/>
              </a:xfrm>
              <a:prstGeom prst="rect">
                <a:avLst/>
              </a:prstGeom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C15D44E-7884-DE70-9F9B-F8920E75B88A}"/>
                  </a:ext>
                </a:extLst>
              </p:cNvPr>
              <p:cNvSpPr txBox="1"/>
              <p:nvPr/>
            </p:nvSpPr>
            <p:spPr>
              <a:xfrm>
                <a:off x="2332806" y="76200"/>
                <a:ext cx="2192388" cy="5232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ticipant 3157</a:t>
                </a:r>
              </a:p>
              <a:p>
                <a:pPr algn="ctr"/>
                <a:r>
                  <a:rPr lang="en-US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(very high bacterial load)</a:t>
                </a:r>
                <a:endParaRPr lang="en-GB" sz="14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BF17B189-4723-9997-7AC4-9FAC7CFE3774}"/>
                  </a:ext>
                </a:extLst>
              </p:cNvPr>
              <p:cNvSpPr/>
              <p:nvPr/>
            </p:nvSpPr>
            <p:spPr>
              <a:xfrm>
                <a:off x="4177671" y="3779575"/>
                <a:ext cx="2113351" cy="2700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8A26D888-4FB3-452C-7AB4-D7FD0008AE6E}"/>
                  </a:ext>
                </a:extLst>
              </p:cNvPr>
              <p:cNvSpPr txBox="1"/>
              <p:nvPr/>
            </p:nvSpPr>
            <p:spPr>
              <a:xfrm>
                <a:off x="4565015" y="4905417"/>
                <a:ext cx="133866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staining detected</a:t>
                </a:r>
                <a:endParaRPr lang="en-GB" sz="12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95586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Group 142">
            <a:extLst>
              <a:ext uri="{FF2B5EF4-FFF2-40B4-BE49-F238E27FC236}">
                <a16:creationId xmlns:a16="http://schemas.microsoft.com/office/drawing/2014/main" id="{523EA93D-2C78-D2F5-AB20-A91A6F3BDF62}"/>
              </a:ext>
            </a:extLst>
          </p:cNvPr>
          <p:cNvGrpSpPr/>
          <p:nvPr/>
        </p:nvGrpSpPr>
        <p:grpSpPr>
          <a:xfrm>
            <a:off x="532658" y="314508"/>
            <a:ext cx="5762204" cy="3942186"/>
            <a:chOff x="547898" y="5963814"/>
            <a:chExt cx="5762204" cy="3942186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84139C0C-B765-1A6A-E5D7-0FD66A8E76F9}"/>
                </a:ext>
              </a:extLst>
            </p:cNvPr>
            <p:cNvGrpSpPr/>
            <p:nvPr/>
          </p:nvGrpSpPr>
          <p:grpSpPr>
            <a:xfrm>
              <a:off x="547898" y="6169422"/>
              <a:ext cx="5762204" cy="3736578"/>
              <a:chOff x="586075" y="3363314"/>
              <a:chExt cx="5762204" cy="3736578"/>
            </a:xfrm>
          </p:grpSpPr>
          <p:graphicFrame>
            <p:nvGraphicFramePr>
              <p:cNvPr id="54" name="Chart 53">
                <a:extLst>
                  <a:ext uri="{FF2B5EF4-FFF2-40B4-BE49-F238E27FC236}">
                    <a16:creationId xmlns:a16="http://schemas.microsoft.com/office/drawing/2014/main" id="{D176DA7C-C7E9-211E-01F9-50D0558B1B3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00489862"/>
                  </p:ext>
                </p:extLst>
              </p:nvPr>
            </p:nvGraphicFramePr>
            <p:xfrm>
              <a:off x="586075" y="3363314"/>
              <a:ext cx="5685853" cy="37365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BFADD99B-D43C-A83F-C747-CAD8E7F5A1EC}"/>
                  </a:ext>
                </a:extLst>
              </p:cNvPr>
              <p:cNvCxnSpPr/>
              <p:nvPr/>
            </p:nvCxnSpPr>
            <p:spPr>
              <a:xfrm>
                <a:off x="1279194" y="5992624"/>
                <a:ext cx="48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65DC30C2-60A6-3F8D-EF19-E8DFAD040617}"/>
                  </a:ext>
                </a:extLst>
              </p:cNvPr>
              <p:cNvGrpSpPr/>
              <p:nvPr/>
            </p:nvGrpSpPr>
            <p:grpSpPr>
              <a:xfrm>
                <a:off x="1264425" y="5946667"/>
                <a:ext cx="848957" cy="807456"/>
                <a:chOff x="1275059" y="5935484"/>
                <a:chExt cx="848957" cy="807456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7C74D19B-641C-B803-7CA3-41B00FEBC678}"/>
                    </a:ext>
                  </a:extLst>
                </p:cNvPr>
                <p:cNvSpPr txBox="1"/>
                <p:nvPr/>
              </p:nvSpPr>
              <p:spPr>
                <a:xfrm>
                  <a:off x="1361664" y="6465941"/>
                  <a:ext cx="6434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GIT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D1C6ABBD-212C-BED4-1B88-2C1375BFAEF5}"/>
                    </a:ext>
                  </a:extLst>
                </p:cNvPr>
                <p:cNvCxnSpPr/>
                <p:nvPr/>
              </p:nvCxnSpPr>
              <p:spPr>
                <a:xfrm>
                  <a:off x="2092115" y="5935484"/>
                  <a:ext cx="0" cy="14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03C5258D-FC71-7006-3AE4-958EC2D7B8D1}"/>
                    </a:ext>
                  </a:extLst>
                </p:cNvPr>
                <p:cNvSpPr txBox="1"/>
                <p:nvPr/>
              </p:nvSpPr>
              <p:spPr>
                <a:xfrm>
                  <a:off x="12750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S 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Left Brace 55">
                  <a:extLst>
                    <a:ext uri="{FF2B5EF4-FFF2-40B4-BE49-F238E27FC236}">
                      <a16:creationId xmlns:a16="http://schemas.microsoft.com/office/drawing/2014/main" id="{90718C66-2F0D-6564-D202-3512CF386F80}"/>
                    </a:ext>
                  </a:extLst>
                </p:cNvPr>
                <p:cNvSpPr/>
                <p:nvPr/>
              </p:nvSpPr>
              <p:spPr>
                <a:xfrm rot="16200000">
                  <a:off x="1643298" y="5939243"/>
                  <a:ext cx="143999" cy="817436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DCBFB4A3-69EE-E724-B767-A76BC88C3A96}"/>
                  </a:ext>
                </a:extLst>
              </p:cNvPr>
              <p:cNvGrpSpPr/>
              <p:nvPr/>
            </p:nvGrpSpPr>
            <p:grpSpPr>
              <a:xfrm>
                <a:off x="2070849" y="5939027"/>
                <a:ext cx="886555" cy="992122"/>
                <a:chOff x="1248600" y="5935484"/>
                <a:chExt cx="886555" cy="992122"/>
              </a:xfrm>
            </p:grpSpPr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31965AF7-D8B5-9011-37D0-1FB308A35514}"/>
                    </a:ext>
                  </a:extLst>
                </p:cNvPr>
                <p:cNvSpPr txBox="1"/>
                <p:nvPr/>
              </p:nvSpPr>
              <p:spPr>
                <a:xfrm>
                  <a:off x="1248600" y="6465941"/>
                  <a:ext cx="86528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uramine smear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F8D5514B-35B3-885B-CA21-D22EEF1944EB}"/>
                    </a:ext>
                  </a:extLst>
                </p:cNvPr>
                <p:cNvCxnSpPr/>
                <p:nvPr/>
              </p:nvCxnSpPr>
              <p:spPr>
                <a:xfrm>
                  <a:off x="2092115" y="5935484"/>
                  <a:ext cx="0" cy="14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C00EAF22-927B-B887-6662-AB434991EBF4}"/>
                    </a:ext>
                  </a:extLst>
                </p:cNvPr>
                <p:cNvSpPr txBox="1"/>
                <p:nvPr/>
              </p:nvSpPr>
              <p:spPr>
                <a:xfrm>
                  <a:off x="13004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 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Left Brace 61">
                  <a:extLst>
                    <a:ext uri="{FF2B5EF4-FFF2-40B4-BE49-F238E27FC236}">
                      <a16:creationId xmlns:a16="http://schemas.microsoft.com/office/drawing/2014/main" id="{0CE65AD2-6725-5329-258B-F414CF94E98A}"/>
                    </a:ext>
                  </a:extLst>
                </p:cNvPr>
                <p:cNvSpPr/>
                <p:nvPr/>
              </p:nvSpPr>
              <p:spPr>
                <a:xfrm rot="16200000">
                  <a:off x="1619946" y="5962593"/>
                  <a:ext cx="144000" cy="79200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201E7C96-6508-FB4C-5233-541687809DFF}"/>
                  </a:ext>
                </a:extLst>
              </p:cNvPr>
              <p:cNvGrpSpPr/>
              <p:nvPr/>
            </p:nvGrpSpPr>
            <p:grpSpPr>
              <a:xfrm>
                <a:off x="2829299" y="5939027"/>
                <a:ext cx="977242" cy="807456"/>
                <a:chOff x="1206068" y="5935484"/>
                <a:chExt cx="977242" cy="807456"/>
              </a:xfrm>
            </p:grpSpPr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DC7815D6-1BFC-F4DE-1780-7EB70082D0A0}"/>
                    </a:ext>
                  </a:extLst>
                </p:cNvPr>
                <p:cNvSpPr txBox="1"/>
                <p:nvPr/>
              </p:nvSpPr>
              <p:spPr>
                <a:xfrm>
                  <a:off x="1206068" y="6465941"/>
                  <a:ext cx="97724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eneXpert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5" name="Straight Connector 64">
                  <a:extLst>
                    <a:ext uri="{FF2B5EF4-FFF2-40B4-BE49-F238E27FC236}">
                      <a16:creationId xmlns:a16="http://schemas.microsoft.com/office/drawing/2014/main" id="{3FF22871-A107-0710-53F3-E14356DC9947}"/>
                    </a:ext>
                  </a:extLst>
                </p:cNvPr>
                <p:cNvCxnSpPr/>
                <p:nvPr/>
              </p:nvCxnSpPr>
              <p:spPr>
                <a:xfrm>
                  <a:off x="2092115" y="5935484"/>
                  <a:ext cx="0" cy="14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C55474A0-5617-85FD-83D2-5256B1225A1A}"/>
                    </a:ext>
                  </a:extLst>
                </p:cNvPr>
                <p:cNvSpPr txBox="1"/>
                <p:nvPr/>
              </p:nvSpPr>
              <p:spPr>
                <a:xfrm>
                  <a:off x="13004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S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Left Brace 66">
                  <a:extLst>
                    <a:ext uri="{FF2B5EF4-FFF2-40B4-BE49-F238E27FC236}">
                      <a16:creationId xmlns:a16="http://schemas.microsoft.com/office/drawing/2014/main" id="{A4D1DB0B-9D83-A5F6-50FB-02731D12B954}"/>
                    </a:ext>
                  </a:extLst>
                </p:cNvPr>
                <p:cNvSpPr/>
                <p:nvPr/>
              </p:nvSpPr>
              <p:spPr>
                <a:xfrm rot="16200000">
                  <a:off x="1619946" y="5962593"/>
                  <a:ext cx="144000" cy="79200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6650D560-2394-9877-AD15-8040FBBBB1D9}"/>
                  </a:ext>
                </a:extLst>
              </p:cNvPr>
              <p:cNvGrpSpPr/>
              <p:nvPr/>
            </p:nvGrpSpPr>
            <p:grpSpPr>
              <a:xfrm>
                <a:off x="3640921" y="5942568"/>
                <a:ext cx="977242" cy="807456"/>
                <a:chOff x="1206068" y="5935484"/>
                <a:chExt cx="977242" cy="807456"/>
              </a:xfrm>
            </p:grpSpPr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CB1C3121-AEEB-2E14-2708-63AEED0D2018}"/>
                    </a:ext>
                  </a:extLst>
                </p:cNvPr>
                <p:cNvSpPr txBox="1"/>
                <p:nvPr/>
              </p:nvSpPr>
              <p:spPr>
                <a:xfrm>
                  <a:off x="1206068" y="6465941"/>
                  <a:ext cx="97724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N-Tre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4066B9AE-C1F3-3A59-6B27-29AF1054CF23}"/>
                    </a:ext>
                  </a:extLst>
                </p:cNvPr>
                <p:cNvCxnSpPr/>
                <p:nvPr/>
              </p:nvCxnSpPr>
              <p:spPr>
                <a:xfrm>
                  <a:off x="2092115" y="5935484"/>
                  <a:ext cx="0" cy="14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8FEC6BB3-68BB-F572-4009-E8F1296E2855}"/>
                    </a:ext>
                  </a:extLst>
                </p:cNvPr>
                <p:cNvSpPr txBox="1"/>
                <p:nvPr/>
              </p:nvSpPr>
              <p:spPr>
                <a:xfrm>
                  <a:off x="13004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 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Left Brace 71">
                  <a:extLst>
                    <a:ext uri="{FF2B5EF4-FFF2-40B4-BE49-F238E27FC236}">
                      <a16:creationId xmlns:a16="http://schemas.microsoft.com/office/drawing/2014/main" id="{D8B5895B-AE8C-1BB1-7806-2080F568A68F}"/>
                    </a:ext>
                  </a:extLst>
                </p:cNvPr>
                <p:cNvSpPr/>
                <p:nvPr/>
              </p:nvSpPr>
              <p:spPr>
                <a:xfrm rot="16200000">
                  <a:off x="1619946" y="5962593"/>
                  <a:ext cx="144000" cy="79200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A452C02A-60A2-7DD6-5B57-23D73851EAE6}"/>
                  </a:ext>
                </a:extLst>
              </p:cNvPr>
              <p:cNvGrpSpPr/>
              <p:nvPr/>
            </p:nvGrpSpPr>
            <p:grpSpPr>
              <a:xfrm>
                <a:off x="4447223" y="5941622"/>
                <a:ext cx="977242" cy="992122"/>
                <a:chOff x="1206068" y="5935484"/>
                <a:chExt cx="977242" cy="992122"/>
              </a:xfrm>
            </p:grpSpPr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04E8A5C4-DD45-537B-0074-6AAF74B6C3A6}"/>
                    </a:ext>
                  </a:extLst>
                </p:cNvPr>
                <p:cNvSpPr txBox="1"/>
                <p:nvPr/>
              </p:nvSpPr>
              <p:spPr>
                <a:xfrm>
                  <a:off x="1206068" y="6465941"/>
                  <a:ext cx="977242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F-augmented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5" name="Straight Connector 74">
                  <a:extLst>
                    <a:ext uri="{FF2B5EF4-FFF2-40B4-BE49-F238E27FC236}">
                      <a16:creationId xmlns:a16="http://schemas.microsoft.com/office/drawing/2014/main" id="{B1F182D4-E498-512F-21CF-55876F27E65B}"/>
                    </a:ext>
                  </a:extLst>
                </p:cNvPr>
                <p:cNvCxnSpPr/>
                <p:nvPr/>
              </p:nvCxnSpPr>
              <p:spPr>
                <a:xfrm>
                  <a:off x="2092115" y="5935484"/>
                  <a:ext cx="0" cy="144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8FB7CDDA-2F9F-2B5C-A7DC-2A4438959D5D}"/>
                    </a:ext>
                  </a:extLst>
                </p:cNvPr>
                <p:cNvSpPr txBox="1"/>
                <p:nvPr/>
              </p:nvSpPr>
              <p:spPr>
                <a:xfrm>
                  <a:off x="13004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 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Left Brace 76">
                  <a:extLst>
                    <a:ext uri="{FF2B5EF4-FFF2-40B4-BE49-F238E27FC236}">
                      <a16:creationId xmlns:a16="http://schemas.microsoft.com/office/drawing/2014/main" id="{B4F19C6B-8B38-2DD8-4D25-F9B924AB3F2B}"/>
                    </a:ext>
                  </a:extLst>
                </p:cNvPr>
                <p:cNvSpPr/>
                <p:nvPr/>
              </p:nvSpPr>
              <p:spPr>
                <a:xfrm rot="16200000">
                  <a:off x="1619946" y="5962593"/>
                  <a:ext cx="144000" cy="79200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87025864-8F46-9EA0-C769-8011584723CF}"/>
                  </a:ext>
                </a:extLst>
              </p:cNvPr>
              <p:cNvGrpSpPr/>
              <p:nvPr/>
            </p:nvGrpSpPr>
            <p:grpSpPr>
              <a:xfrm>
                <a:off x="5251062" y="6039511"/>
                <a:ext cx="1097217" cy="896492"/>
                <a:chOff x="1206067" y="6031114"/>
                <a:chExt cx="1097217" cy="896492"/>
              </a:xfrm>
            </p:grpSpPr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A9AE6B55-1390-0078-5E76-D7221E7912D6}"/>
                    </a:ext>
                  </a:extLst>
                </p:cNvPr>
                <p:cNvSpPr txBox="1"/>
                <p:nvPr/>
              </p:nvSpPr>
              <p:spPr>
                <a:xfrm>
                  <a:off x="1206067" y="6465941"/>
                  <a:ext cx="109721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F-independent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59E53F69-3717-4DF2-8B83-6AFB974109DE}"/>
                    </a:ext>
                  </a:extLst>
                </p:cNvPr>
                <p:cNvSpPr txBox="1"/>
                <p:nvPr/>
              </p:nvSpPr>
              <p:spPr>
                <a:xfrm>
                  <a:off x="1300459" y="6031114"/>
                  <a:ext cx="8346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        Ts</a:t>
                  </a:r>
                  <a:endParaRPr lang="en-GB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Left Brace 81">
                  <a:extLst>
                    <a:ext uri="{FF2B5EF4-FFF2-40B4-BE49-F238E27FC236}">
                      <a16:creationId xmlns:a16="http://schemas.microsoft.com/office/drawing/2014/main" id="{22F8D47D-499B-39BB-4944-E505A3ED0F01}"/>
                    </a:ext>
                  </a:extLst>
                </p:cNvPr>
                <p:cNvSpPr/>
                <p:nvPr/>
              </p:nvSpPr>
              <p:spPr>
                <a:xfrm rot="16200000">
                  <a:off x="1619946" y="5962593"/>
                  <a:ext cx="144000" cy="79200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</p:grp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382B2F71-93EF-6A3F-E28D-A2F5253B4CA6}"/>
                </a:ext>
              </a:extLst>
            </p:cNvPr>
            <p:cNvGrpSpPr/>
            <p:nvPr/>
          </p:nvGrpSpPr>
          <p:grpSpPr>
            <a:xfrm>
              <a:off x="1303236" y="6423999"/>
              <a:ext cx="1213903" cy="559418"/>
              <a:chOff x="797529" y="484506"/>
              <a:chExt cx="4421376" cy="1381454"/>
            </a:xfrm>
          </p:grpSpPr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601C98C5-0D75-0121-F451-5B43FA431912}"/>
                  </a:ext>
                </a:extLst>
              </p:cNvPr>
              <p:cNvGrpSpPr/>
              <p:nvPr/>
            </p:nvGrpSpPr>
            <p:grpSpPr>
              <a:xfrm>
                <a:off x="797529" y="484506"/>
                <a:ext cx="4421376" cy="627033"/>
                <a:chOff x="1322601" y="577891"/>
                <a:chExt cx="1668801" cy="627033"/>
              </a:xfrm>
            </p:grpSpPr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D00EB1F9-129A-BB80-93DE-392865DA3698}"/>
                    </a:ext>
                  </a:extLst>
                </p:cNvPr>
                <p:cNvSpPr txBox="1"/>
                <p:nvPr/>
              </p:nvSpPr>
              <p:spPr>
                <a:xfrm>
                  <a:off x="1322601" y="577891"/>
                  <a:ext cx="1668801" cy="627033"/>
                </a:xfrm>
                <a:prstGeom prst="rect">
                  <a:avLst/>
                </a:prstGeom>
                <a:noFill/>
                <a:ln w="19050">
                  <a:noFill/>
                  <a:extLst>
                    <a:ext uri="{C807C97D-BFC1-408E-A445-0C87EB9F89A2}">
                      <ask:lineSketchStyleProps xmlns:ask="http://schemas.microsoft.com/office/drawing/2018/sketchyshapes"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 </a:t>
                  </a: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P = 0.7055)</a:t>
                  </a:r>
                  <a:endParaRPr lang="en-GB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4" name="Straight Connector 123">
                  <a:extLst>
                    <a:ext uri="{FF2B5EF4-FFF2-40B4-BE49-F238E27FC236}">
                      <a16:creationId xmlns:a16="http://schemas.microsoft.com/office/drawing/2014/main" id="{0664181F-6A6C-2513-152B-0BB226DF8E63}"/>
                    </a:ext>
                  </a:extLst>
                </p:cNvPr>
                <p:cNvCxnSpPr/>
                <p:nvPr/>
              </p:nvCxnSpPr>
              <p:spPr>
                <a:xfrm>
                  <a:off x="1640936" y="1184463"/>
                  <a:ext cx="108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397722F4-F388-B934-0652-899E6280243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04603" y="1469959"/>
                <a:ext cx="79200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9281B4A4-4DB4-B597-5E87-0427A4DC5618}"/>
                </a:ext>
              </a:extLst>
            </p:cNvPr>
            <p:cNvGrpSpPr/>
            <p:nvPr/>
          </p:nvGrpSpPr>
          <p:grpSpPr>
            <a:xfrm>
              <a:off x="1419424" y="6206608"/>
              <a:ext cx="1872000" cy="546718"/>
              <a:chOff x="1405701" y="515868"/>
              <a:chExt cx="3409174" cy="1350092"/>
            </a:xfrm>
          </p:grpSpPr>
          <p:grpSp>
            <p:nvGrpSpPr>
              <p:cNvPr id="126" name="Group 125">
                <a:extLst>
                  <a:ext uri="{FF2B5EF4-FFF2-40B4-BE49-F238E27FC236}">
                    <a16:creationId xmlns:a16="http://schemas.microsoft.com/office/drawing/2014/main" id="{9522C30B-7CD3-C29F-60E3-407D636CE816}"/>
                  </a:ext>
                </a:extLst>
              </p:cNvPr>
              <p:cNvGrpSpPr/>
              <p:nvPr/>
            </p:nvGrpSpPr>
            <p:grpSpPr>
              <a:xfrm>
                <a:off x="1405701" y="515868"/>
                <a:ext cx="3409174" cy="627032"/>
                <a:chOff x="1552149" y="609253"/>
                <a:chExt cx="1286756" cy="627032"/>
              </a:xfrm>
            </p:grpSpPr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0C4F4694-8CF6-FD92-0B5F-C1F2D417A533}"/>
                    </a:ext>
                  </a:extLst>
                </p:cNvPr>
                <p:cNvSpPr txBox="1"/>
                <p:nvPr/>
              </p:nvSpPr>
              <p:spPr>
                <a:xfrm>
                  <a:off x="1552149" y="609253"/>
                  <a:ext cx="1286756" cy="627032"/>
                </a:xfrm>
                <a:prstGeom prst="rect">
                  <a:avLst/>
                </a:prstGeom>
                <a:noFill/>
                <a:ln w="19050">
                  <a:noFill/>
                  <a:extLst>
                    <a:ext uri="{C807C97D-BFC1-408E-A445-0C87EB9F89A2}">
                      <ask:lineSketchStyleProps xmlns:ask="http://schemas.microsoft.com/office/drawing/2018/sketchyshapes"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 </a:t>
                  </a: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P = 0.3173)</a:t>
                  </a:r>
                  <a:endParaRPr lang="en-GB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9" name="Straight Connector 128">
                  <a:extLst>
                    <a:ext uri="{FF2B5EF4-FFF2-40B4-BE49-F238E27FC236}">
                      <a16:creationId xmlns:a16="http://schemas.microsoft.com/office/drawing/2014/main" id="{09350E66-E1EC-EE00-CDCB-7F187159E62F}"/>
                    </a:ext>
                  </a:extLst>
                </p:cNvPr>
                <p:cNvCxnSpPr/>
                <p:nvPr/>
              </p:nvCxnSpPr>
              <p:spPr>
                <a:xfrm>
                  <a:off x="1640936" y="1184463"/>
                  <a:ext cx="108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id="{60D20BEF-9165-597F-DE4D-C91DF7CCC6A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04603" y="1469959"/>
                <a:ext cx="79200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D86B2643-B620-C18F-5F03-538A99215546}"/>
                </a:ext>
              </a:extLst>
            </p:cNvPr>
            <p:cNvGrpSpPr/>
            <p:nvPr/>
          </p:nvGrpSpPr>
          <p:grpSpPr>
            <a:xfrm>
              <a:off x="1308870" y="5963814"/>
              <a:ext cx="3744000" cy="559418"/>
              <a:chOff x="1405701" y="484506"/>
              <a:chExt cx="3409174" cy="1381454"/>
            </a:xfrm>
          </p:grpSpPr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46BEEB75-D729-71B5-1DAB-042F5F2D4871}"/>
                  </a:ext>
                </a:extLst>
              </p:cNvPr>
              <p:cNvGrpSpPr/>
              <p:nvPr/>
            </p:nvGrpSpPr>
            <p:grpSpPr>
              <a:xfrm>
                <a:off x="1405701" y="484506"/>
                <a:ext cx="3409174" cy="627032"/>
                <a:chOff x="1552149" y="577891"/>
                <a:chExt cx="1286756" cy="627032"/>
              </a:xfrm>
            </p:grpSpPr>
            <p:sp>
              <p:nvSpPr>
                <p:cNvPr id="133" name="TextBox 132">
                  <a:extLst>
                    <a:ext uri="{FF2B5EF4-FFF2-40B4-BE49-F238E27FC236}">
                      <a16:creationId xmlns:a16="http://schemas.microsoft.com/office/drawing/2014/main" id="{FA3442B4-8FC9-D2F6-A63C-CD4D82B4FE2E}"/>
                    </a:ext>
                  </a:extLst>
                </p:cNvPr>
                <p:cNvSpPr txBox="1"/>
                <p:nvPr/>
              </p:nvSpPr>
              <p:spPr>
                <a:xfrm>
                  <a:off x="1552149" y="577891"/>
                  <a:ext cx="1286756" cy="627032"/>
                </a:xfrm>
                <a:prstGeom prst="rect">
                  <a:avLst/>
                </a:prstGeom>
                <a:noFill/>
                <a:ln w="19050">
                  <a:noFill/>
                  <a:extLst>
                    <a:ext uri="{C807C97D-BFC1-408E-A445-0C87EB9F89A2}">
                      <ask:lineSketchStyleProps xmlns:ask="http://schemas.microsoft.com/office/drawing/2018/sketchyshapes"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5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 </a:t>
                  </a: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P = 0.6547)</a:t>
                  </a:r>
                  <a:endParaRPr lang="en-GB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CD99B65E-A7FB-72F7-503B-03CB411A6A0C}"/>
                    </a:ext>
                  </a:extLst>
                </p:cNvPr>
                <p:cNvCxnSpPr/>
                <p:nvPr/>
              </p:nvCxnSpPr>
              <p:spPr>
                <a:xfrm>
                  <a:off x="1640936" y="1184463"/>
                  <a:ext cx="108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337D7BDF-297A-C4AB-4674-FF7DB4B25C9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04603" y="1469959"/>
                <a:ext cx="79200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CCE35F41-A900-0475-BB34-4FD0BE4823A8}"/>
                </a:ext>
              </a:extLst>
            </p:cNvPr>
            <p:cNvSpPr txBox="1"/>
            <p:nvPr/>
          </p:nvSpPr>
          <p:spPr>
            <a:xfrm>
              <a:off x="1746721" y="7501777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33AB4EC-927A-F147-592F-76B38F085EC0}"/>
                </a:ext>
              </a:extLst>
            </p:cNvPr>
            <p:cNvSpPr txBox="1"/>
            <p:nvPr/>
          </p:nvSpPr>
          <p:spPr>
            <a:xfrm>
              <a:off x="2532594" y="8515536"/>
              <a:ext cx="360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42BDC81-DDAA-74E6-14FC-CEC55DA15883}"/>
                </a:ext>
              </a:extLst>
            </p:cNvPr>
            <p:cNvSpPr txBox="1"/>
            <p:nvPr/>
          </p:nvSpPr>
          <p:spPr>
            <a:xfrm>
              <a:off x="3349359" y="8170178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AA9373A-AEF4-6176-BCBC-9DC7430C1724}"/>
                </a:ext>
              </a:extLst>
            </p:cNvPr>
            <p:cNvSpPr txBox="1"/>
            <p:nvPr/>
          </p:nvSpPr>
          <p:spPr>
            <a:xfrm>
              <a:off x="3759689" y="7893225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136A632C-EAE8-0985-A677-61EC780B8E4D}"/>
                </a:ext>
              </a:extLst>
            </p:cNvPr>
            <p:cNvSpPr txBox="1"/>
            <p:nvPr/>
          </p:nvSpPr>
          <p:spPr>
            <a:xfrm>
              <a:off x="4163097" y="8177102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4B7392B9-4C69-1027-8A3F-1EFF6C313EB4}"/>
                </a:ext>
              </a:extLst>
            </p:cNvPr>
            <p:cNvSpPr txBox="1"/>
            <p:nvPr/>
          </p:nvSpPr>
          <p:spPr>
            <a:xfrm>
              <a:off x="4953276" y="7043213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22AE15B8-33AA-DAB9-61F5-9893B7790144}"/>
                </a:ext>
              </a:extLst>
            </p:cNvPr>
            <p:cNvSpPr txBox="1"/>
            <p:nvPr/>
          </p:nvSpPr>
          <p:spPr>
            <a:xfrm>
              <a:off x="5354292" y="7798281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900" b="1" dirty="0"/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839B62C-976A-EC87-00B4-6023402612EC}"/>
                </a:ext>
              </a:extLst>
            </p:cNvPr>
            <p:cNvSpPr txBox="1"/>
            <p:nvPr/>
          </p:nvSpPr>
          <p:spPr>
            <a:xfrm>
              <a:off x="5775646" y="8172192"/>
              <a:ext cx="3240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b="1" dirty="0"/>
            </a:p>
          </p:txBody>
        </p:sp>
      </p:grpSp>
      <p:sp>
        <p:nvSpPr>
          <p:cNvPr id="144" name="TextBox 143">
            <a:extLst>
              <a:ext uri="{FF2B5EF4-FFF2-40B4-BE49-F238E27FC236}">
                <a16:creationId xmlns:a16="http://schemas.microsoft.com/office/drawing/2014/main" id="{DA810C11-3C13-B6F2-02B7-F70442FE75AF}"/>
              </a:ext>
            </a:extLst>
          </p:cNvPr>
          <p:cNvSpPr txBox="1"/>
          <p:nvPr/>
        </p:nvSpPr>
        <p:spPr>
          <a:xfrm>
            <a:off x="63000" y="4318730"/>
            <a:ext cx="6732000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Overall positivity of all tests used to assess the performed of sputum and tongue swabs stratified by HIV-statu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sitivity rate (%) for MGIT, Auramine smear, GeneXpert, MPN and DMN-Tre using sputum or tongue swab samples as a function of total number of participants per HIV-group (N = 31 for </a:t>
            </a:r>
            <a:r>
              <a:rPr lang="en-US" sz="11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V-positive (green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 N = 53 for </a:t>
            </a:r>
            <a:r>
              <a:rPr lang="en-US" sz="11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V-negative (grey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As MGIT culture on sputum is considered the clinical standard, it was used as the reference sample for statistical testing.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cNema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est was thus used to calculate statistical significance between sputum and tongue swabs for each tests, relative to the MGIT performed on sputum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5 was used as the cut-off for statistically significant differences. Significance is denoted as a ** or * which represente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values &lt;0.0001 or &lt;0.05, respectively. No statistical significance was denoted by ‘NS’. Note that statistical testing failed on the HIV-positive group since all MGIT results were positive leading to no variability in the comparisons (all comparisons and statistical significance are summarized in Supplementary Table 1). </a:t>
            </a:r>
          </a:p>
        </p:txBody>
      </p:sp>
    </p:spTree>
    <p:extLst>
      <p:ext uri="{BB962C8B-B14F-4D97-AF65-F5344CB8AC3E}">
        <p14:creationId xmlns:p14="http://schemas.microsoft.com/office/powerpoint/2010/main" val="645663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97</Words>
  <Application>Microsoft Office PowerPoint</Application>
  <PresentationFormat>A4 Paper (210x297 mm)</PresentationFormat>
  <Paragraphs>7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Ealand</dc:creator>
  <cp:lastModifiedBy>Christopher Ealand</cp:lastModifiedBy>
  <cp:revision>7</cp:revision>
  <dcterms:created xsi:type="dcterms:W3CDTF">2023-01-12T07:54:16Z</dcterms:created>
  <dcterms:modified xsi:type="dcterms:W3CDTF">2023-08-07T13:04:29Z</dcterms:modified>
</cp:coreProperties>
</file>